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6" r:id="rId2"/>
    <p:sldId id="273" r:id="rId3"/>
    <p:sldId id="274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565713-7EE2-4C12-9F19-1EC6598428A5}" v="87" dt="2024-06-04T08:28:34.32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904" autoAdjust="0"/>
    <p:restoredTop sz="80688" autoAdjust="0"/>
  </p:normalViewPr>
  <p:slideViewPr>
    <p:cSldViewPr snapToGrid="0">
      <p:cViewPr varScale="1">
        <p:scale>
          <a:sx n="92" d="100"/>
          <a:sy n="92" d="100"/>
        </p:scale>
        <p:origin x="183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美紀 織田" userId="9572cbd499a75355" providerId="LiveId" clId="{65565713-7EE2-4C12-9F19-1EC6598428A5}"/>
    <pc:docChg chg="undo custSel addSld delSld modSld sldOrd">
      <pc:chgData name="美紀 織田" userId="9572cbd499a75355" providerId="LiveId" clId="{65565713-7EE2-4C12-9F19-1EC6598428A5}" dt="2024-06-04T08:29:11.732" v="1127" actId="20577"/>
      <pc:docMkLst>
        <pc:docMk/>
      </pc:docMkLst>
      <pc:sldChg chg="del">
        <pc:chgData name="美紀 織田" userId="9572cbd499a75355" providerId="LiveId" clId="{65565713-7EE2-4C12-9F19-1EC6598428A5}" dt="2024-06-04T07:41:41.642" v="743" actId="47"/>
        <pc:sldMkLst>
          <pc:docMk/>
          <pc:sldMk cId="2773237011" sldId="256"/>
        </pc:sldMkLst>
      </pc:sldChg>
      <pc:sldChg chg="addSp delSp modSp mod">
        <pc:chgData name="美紀 織田" userId="9572cbd499a75355" providerId="LiveId" clId="{65565713-7EE2-4C12-9F19-1EC6598428A5}" dt="2024-06-04T08:27:08.257" v="1082" actId="1035"/>
        <pc:sldMkLst>
          <pc:docMk/>
          <pc:sldMk cId="493461597" sldId="257"/>
        </pc:sldMkLst>
        <pc:spChg chg="add mod">
          <ac:chgData name="美紀 織田" userId="9572cbd499a75355" providerId="LiveId" clId="{65565713-7EE2-4C12-9F19-1EC6598428A5}" dt="2024-06-04T07:58:13.005" v="841" actId="1036"/>
          <ac:spMkLst>
            <pc:docMk/>
            <pc:sldMk cId="493461597" sldId="257"/>
            <ac:spMk id="3" creationId="{D2B51CF6-547B-E791-4133-FFDBC0E3158C}"/>
          </ac:spMkLst>
        </pc:spChg>
        <pc:spChg chg="add mod">
          <ac:chgData name="美紀 織田" userId="9572cbd499a75355" providerId="LiveId" clId="{65565713-7EE2-4C12-9F19-1EC6598428A5}" dt="2024-06-04T07:38:37.800" v="719" actId="1035"/>
          <ac:spMkLst>
            <pc:docMk/>
            <pc:sldMk cId="493461597" sldId="257"/>
            <ac:spMk id="4" creationId="{64C90F7B-EA7D-6DC2-FD7F-348B6E4E4073}"/>
          </ac:spMkLst>
        </pc:spChg>
        <pc:spChg chg="add mod">
          <ac:chgData name="美紀 織田" userId="9572cbd499a75355" providerId="LiveId" clId="{65565713-7EE2-4C12-9F19-1EC6598428A5}" dt="2024-06-04T07:37:05.152" v="700" actId="1076"/>
          <ac:spMkLst>
            <pc:docMk/>
            <pc:sldMk cId="493461597" sldId="257"/>
            <ac:spMk id="9" creationId="{E7147F8B-1C72-DA8A-9534-BF8667DA62CE}"/>
          </ac:spMkLst>
        </pc:spChg>
        <pc:spChg chg="add mod">
          <ac:chgData name="美紀 織田" userId="9572cbd499a75355" providerId="LiveId" clId="{65565713-7EE2-4C12-9F19-1EC6598428A5}" dt="2024-06-04T07:38:28.750" v="716" actId="1076"/>
          <ac:spMkLst>
            <pc:docMk/>
            <pc:sldMk cId="493461597" sldId="257"/>
            <ac:spMk id="11" creationId="{447A46C2-EB6F-6DC1-BB8C-49A472A40266}"/>
          </ac:spMkLst>
        </pc:spChg>
        <pc:spChg chg="add mod">
          <ac:chgData name="美紀 織田" userId="9572cbd499a75355" providerId="LiveId" clId="{65565713-7EE2-4C12-9F19-1EC6598428A5}" dt="2024-06-04T07:58:23.130" v="843" actId="1035"/>
          <ac:spMkLst>
            <pc:docMk/>
            <pc:sldMk cId="493461597" sldId="257"/>
            <ac:spMk id="12" creationId="{B98971A9-AEC2-DDDA-C056-67D27A4B9734}"/>
          </ac:spMkLst>
        </pc:spChg>
        <pc:spChg chg="add mod">
          <ac:chgData name="美紀 織田" userId="9572cbd499a75355" providerId="LiveId" clId="{65565713-7EE2-4C12-9F19-1EC6598428A5}" dt="2024-06-04T07:58:23.130" v="843" actId="1035"/>
          <ac:spMkLst>
            <pc:docMk/>
            <pc:sldMk cId="493461597" sldId="257"/>
            <ac:spMk id="13" creationId="{A26D182B-F06F-A7EF-982E-44229AC51225}"/>
          </ac:spMkLst>
        </pc:spChg>
        <pc:spChg chg="add mod">
          <ac:chgData name="美紀 織田" userId="9572cbd499a75355" providerId="LiveId" clId="{65565713-7EE2-4C12-9F19-1EC6598428A5}" dt="2024-06-04T07:58:02.117" v="839" actId="1036"/>
          <ac:spMkLst>
            <pc:docMk/>
            <pc:sldMk cId="493461597" sldId="257"/>
            <ac:spMk id="14" creationId="{28A8591F-5796-AEF3-2AB3-5B4642DFDBD1}"/>
          </ac:spMkLst>
        </pc:spChg>
        <pc:spChg chg="add mod">
          <ac:chgData name="美紀 織田" userId="9572cbd499a75355" providerId="LiveId" clId="{65565713-7EE2-4C12-9F19-1EC6598428A5}" dt="2024-06-04T07:58:23.130" v="843" actId="1035"/>
          <ac:spMkLst>
            <pc:docMk/>
            <pc:sldMk cId="493461597" sldId="257"/>
            <ac:spMk id="15" creationId="{D7179AD3-E9C3-BD6F-E0B5-9EDE6AB4BB70}"/>
          </ac:spMkLst>
        </pc:spChg>
        <pc:spChg chg="del mod">
          <ac:chgData name="美紀 織田" userId="9572cbd499a75355" providerId="LiveId" clId="{65565713-7EE2-4C12-9F19-1EC6598428A5}" dt="2024-06-04T07:26:16.028" v="632" actId="478"/>
          <ac:spMkLst>
            <pc:docMk/>
            <pc:sldMk cId="493461597" sldId="257"/>
            <ac:spMk id="16" creationId="{211EC673-C20B-59AA-6B92-ECF079D797CE}"/>
          </ac:spMkLst>
        </pc:spChg>
        <pc:spChg chg="add del mod">
          <ac:chgData name="美紀 織田" userId="9572cbd499a75355" providerId="LiveId" clId="{65565713-7EE2-4C12-9F19-1EC6598428A5}" dt="2024-06-04T08:21:49.983" v="912" actId="1036"/>
          <ac:spMkLst>
            <pc:docMk/>
            <pc:sldMk cId="493461597" sldId="257"/>
            <ac:spMk id="16" creationId="{A95D3267-0890-A922-BDDE-6641BA9537FB}"/>
          </ac:spMkLst>
        </pc:spChg>
        <pc:spChg chg="add del mod">
          <ac:chgData name="美紀 織田" userId="9572cbd499a75355" providerId="LiveId" clId="{65565713-7EE2-4C12-9F19-1EC6598428A5}" dt="2024-06-04T07:56:46.398" v="805" actId="478"/>
          <ac:spMkLst>
            <pc:docMk/>
            <pc:sldMk cId="493461597" sldId="257"/>
            <ac:spMk id="17" creationId="{DE3C7133-D312-A10C-4438-D66B2344B346}"/>
          </ac:spMkLst>
        </pc:spChg>
        <pc:spChg chg="mod">
          <ac:chgData name="美紀 織田" userId="9572cbd499a75355" providerId="LiveId" clId="{65565713-7EE2-4C12-9F19-1EC6598428A5}" dt="2024-06-04T07:58:02.117" v="839" actId="1036"/>
          <ac:spMkLst>
            <pc:docMk/>
            <pc:sldMk cId="493461597" sldId="257"/>
            <ac:spMk id="18" creationId="{AF42C239-960F-7491-614F-1C92D0FF782A}"/>
          </ac:spMkLst>
        </pc:spChg>
        <pc:spChg chg="del mod">
          <ac:chgData name="美紀 織田" userId="9572cbd499a75355" providerId="LiveId" clId="{65565713-7EE2-4C12-9F19-1EC6598428A5}" dt="2024-06-04T07:56:35.315" v="802" actId="478"/>
          <ac:spMkLst>
            <pc:docMk/>
            <pc:sldMk cId="493461597" sldId="257"/>
            <ac:spMk id="19" creationId="{63B5DDA9-C638-C43A-E6E9-48BCC0BE9401}"/>
          </ac:spMkLst>
        </pc:spChg>
        <pc:spChg chg="add del mod">
          <ac:chgData name="美紀 織田" userId="9572cbd499a75355" providerId="LiveId" clId="{65565713-7EE2-4C12-9F19-1EC6598428A5}" dt="2024-06-04T07:56:46.398" v="805" actId="478"/>
          <ac:spMkLst>
            <pc:docMk/>
            <pc:sldMk cId="493461597" sldId="257"/>
            <ac:spMk id="20" creationId="{6B0E140E-1790-7F4B-8D35-F9753FBE8953}"/>
          </ac:spMkLst>
        </pc:spChg>
        <pc:spChg chg="add del mod">
          <ac:chgData name="美紀 織田" userId="9572cbd499a75355" providerId="LiveId" clId="{65565713-7EE2-4C12-9F19-1EC6598428A5}" dt="2024-06-04T07:56:46.398" v="805" actId="478"/>
          <ac:spMkLst>
            <pc:docMk/>
            <pc:sldMk cId="493461597" sldId="257"/>
            <ac:spMk id="21" creationId="{13E4FE8A-BA0E-D28B-2444-93885948F76A}"/>
          </ac:spMkLst>
        </pc:spChg>
        <pc:spChg chg="mod">
          <ac:chgData name="美紀 織田" userId="9572cbd499a75355" providerId="LiveId" clId="{65565713-7EE2-4C12-9F19-1EC6598428A5}" dt="2024-06-04T06:37:11.468" v="482" actId="2711"/>
          <ac:spMkLst>
            <pc:docMk/>
            <pc:sldMk cId="493461597" sldId="257"/>
            <ac:spMk id="22" creationId="{8DE2B27C-7327-0117-B376-FC5D9756390C}"/>
          </ac:spMkLst>
        </pc:spChg>
        <pc:spChg chg="mod">
          <ac:chgData name="美紀 織田" userId="9572cbd499a75355" providerId="LiveId" clId="{65565713-7EE2-4C12-9F19-1EC6598428A5}" dt="2024-06-04T06:37:11.468" v="482" actId="2711"/>
          <ac:spMkLst>
            <pc:docMk/>
            <pc:sldMk cId="493461597" sldId="257"/>
            <ac:spMk id="23" creationId="{C40180E5-B7A2-3B91-6CFC-E09FF77C17E9}"/>
          </ac:spMkLst>
        </pc:spChg>
        <pc:spChg chg="mod">
          <ac:chgData name="美紀 織田" userId="9572cbd499a75355" providerId="LiveId" clId="{65565713-7EE2-4C12-9F19-1EC6598428A5}" dt="2024-06-04T06:37:11.468" v="482" actId="2711"/>
          <ac:spMkLst>
            <pc:docMk/>
            <pc:sldMk cId="493461597" sldId="257"/>
            <ac:spMk id="24" creationId="{AC8D07B6-82F7-CA60-CF4A-34F04BE33880}"/>
          </ac:spMkLst>
        </pc:spChg>
        <pc:spChg chg="mod">
          <ac:chgData name="美紀 織田" userId="9572cbd499a75355" providerId="LiveId" clId="{65565713-7EE2-4C12-9F19-1EC6598428A5}" dt="2024-06-04T06:37:11.468" v="482" actId="2711"/>
          <ac:spMkLst>
            <pc:docMk/>
            <pc:sldMk cId="493461597" sldId="257"/>
            <ac:spMk id="25" creationId="{A51E33CA-B6DF-CAE1-9248-41C5D60A5A88}"/>
          </ac:spMkLst>
        </pc:spChg>
        <pc:spChg chg="mod">
          <ac:chgData name="美紀 織田" userId="9572cbd499a75355" providerId="LiveId" clId="{65565713-7EE2-4C12-9F19-1EC6598428A5}" dt="2024-06-04T06:37:11.468" v="482" actId="2711"/>
          <ac:spMkLst>
            <pc:docMk/>
            <pc:sldMk cId="493461597" sldId="257"/>
            <ac:spMk id="26" creationId="{AD019198-69A1-6590-4B8E-599E8260B98D}"/>
          </ac:spMkLst>
        </pc:spChg>
        <pc:spChg chg="mod">
          <ac:chgData name="美紀 織田" userId="9572cbd499a75355" providerId="LiveId" clId="{65565713-7EE2-4C12-9F19-1EC6598428A5}" dt="2024-06-04T06:37:11.468" v="482" actId="2711"/>
          <ac:spMkLst>
            <pc:docMk/>
            <pc:sldMk cId="493461597" sldId="257"/>
            <ac:spMk id="27" creationId="{F128C879-01D5-C1D2-D6B6-E4A071B028C8}"/>
          </ac:spMkLst>
        </pc:spChg>
        <pc:spChg chg="add mod">
          <ac:chgData name="美紀 織田" userId="9572cbd499a75355" providerId="LiveId" clId="{65565713-7EE2-4C12-9F19-1EC6598428A5}" dt="2024-06-04T08:21:59.156" v="921" actId="1038"/>
          <ac:spMkLst>
            <pc:docMk/>
            <pc:sldMk cId="493461597" sldId="257"/>
            <ac:spMk id="28" creationId="{979C35B5-0C40-4F3E-8C77-91A7B5D3FF3A}"/>
          </ac:spMkLst>
        </pc:spChg>
        <pc:spChg chg="add mod">
          <ac:chgData name="美紀 織田" userId="9572cbd499a75355" providerId="LiveId" clId="{65565713-7EE2-4C12-9F19-1EC6598428A5}" dt="2024-06-04T08:21:45.404" v="902" actId="1036"/>
          <ac:spMkLst>
            <pc:docMk/>
            <pc:sldMk cId="493461597" sldId="257"/>
            <ac:spMk id="29" creationId="{1EAE4787-B1B3-429C-ECEE-B2962A42F952}"/>
          </ac:spMkLst>
        </pc:spChg>
        <pc:spChg chg="add mod">
          <ac:chgData name="美紀 織田" userId="9572cbd499a75355" providerId="LiveId" clId="{65565713-7EE2-4C12-9F19-1EC6598428A5}" dt="2024-06-04T08:22:45.740" v="949" actId="1037"/>
          <ac:spMkLst>
            <pc:docMk/>
            <pc:sldMk cId="493461597" sldId="257"/>
            <ac:spMk id="30" creationId="{098815E1-873E-D226-0ED1-49A4CCE0DEBD}"/>
          </ac:spMkLst>
        </pc:spChg>
        <pc:spChg chg="add mod">
          <ac:chgData name="美紀 織田" userId="9572cbd499a75355" providerId="LiveId" clId="{65565713-7EE2-4C12-9F19-1EC6598428A5}" dt="2024-06-04T08:24:16.345" v="982" actId="1037"/>
          <ac:spMkLst>
            <pc:docMk/>
            <pc:sldMk cId="493461597" sldId="257"/>
            <ac:spMk id="31" creationId="{CB378A0F-14B8-6530-51C5-AA0169F4BDDE}"/>
          </ac:spMkLst>
        </pc:spChg>
        <pc:spChg chg="add mod">
          <ac:chgData name="美紀 織田" userId="9572cbd499a75355" providerId="LiveId" clId="{65565713-7EE2-4C12-9F19-1EC6598428A5}" dt="2024-06-04T08:23:54.760" v="970" actId="1038"/>
          <ac:spMkLst>
            <pc:docMk/>
            <pc:sldMk cId="493461597" sldId="257"/>
            <ac:spMk id="32" creationId="{43160804-91FA-9AD0-8C6D-F0AE51A43F43}"/>
          </ac:spMkLst>
        </pc:spChg>
        <pc:spChg chg="add mod">
          <ac:chgData name="美紀 織田" userId="9572cbd499a75355" providerId="LiveId" clId="{65565713-7EE2-4C12-9F19-1EC6598428A5}" dt="2024-06-04T08:24:36.031" v="998" actId="1076"/>
          <ac:spMkLst>
            <pc:docMk/>
            <pc:sldMk cId="493461597" sldId="257"/>
            <ac:spMk id="33" creationId="{25E3DE28-BF41-7BEB-1C95-65DCC8C2CDB5}"/>
          </ac:spMkLst>
        </pc:spChg>
        <pc:spChg chg="add mod">
          <ac:chgData name="美紀 織田" userId="9572cbd499a75355" providerId="LiveId" clId="{65565713-7EE2-4C12-9F19-1EC6598428A5}" dt="2024-06-04T08:24:54.914" v="1025" actId="1038"/>
          <ac:spMkLst>
            <pc:docMk/>
            <pc:sldMk cId="493461597" sldId="257"/>
            <ac:spMk id="34" creationId="{08AA243A-8F79-148E-A3F2-DED4F75D4B41}"/>
          </ac:spMkLst>
        </pc:spChg>
        <pc:spChg chg="add mod">
          <ac:chgData name="美紀 織田" userId="9572cbd499a75355" providerId="LiveId" clId="{65565713-7EE2-4C12-9F19-1EC6598428A5}" dt="2024-06-04T08:25:48.342" v="1048" actId="20577"/>
          <ac:spMkLst>
            <pc:docMk/>
            <pc:sldMk cId="493461597" sldId="257"/>
            <ac:spMk id="35" creationId="{5203C475-FDA4-75BA-4F19-5DAF30E5826B}"/>
          </ac:spMkLst>
        </pc:spChg>
        <pc:spChg chg="add mod">
          <ac:chgData name="美紀 織田" userId="9572cbd499a75355" providerId="LiveId" clId="{65565713-7EE2-4C12-9F19-1EC6598428A5}" dt="2024-06-04T08:25:45.436" v="1046" actId="20577"/>
          <ac:spMkLst>
            <pc:docMk/>
            <pc:sldMk cId="493461597" sldId="257"/>
            <ac:spMk id="36" creationId="{53164688-435C-3CDA-4899-843D4D36260E}"/>
          </ac:spMkLst>
        </pc:spChg>
        <pc:spChg chg="add mod">
          <ac:chgData name="美紀 織田" userId="9572cbd499a75355" providerId="LiveId" clId="{65565713-7EE2-4C12-9F19-1EC6598428A5}" dt="2024-06-04T08:27:08.257" v="1082" actId="1035"/>
          <ac:spMkLst>
            <pc:docMk/>
            <pc:sldMk cId="493461597" sldId="257"/>
            <ac:spMk id="37" creationId="{F2CA1B89-B9A3-96BE-6808-5A76FF07BF72}"/>
          </ac:spMkLst>
        </pc:spChg>
        <pc:spChg chg="add mod">
          <ac:chgData name="美紀 織田" userId="9572cbd499a75355" providerId="LiveId" clId="{65565713-7EE2-4C12-9F19-1EC6598428A5}" dt="2024-06-04T08:26:48.978" v="1073" actId="1038"/>
          <ac:spMkLst>
            <pc:docMk/>
            <pc:sldMk cId="493461597" sldId="257"/>
            <ac:spMk id="38" creationId="{DA4CEDF6-07B1-A578-580D-5E88EFF2F58C}"/>
          </ac:spMkLst>
        </pc:spChg>
        <pc:graphicFrameChg chg="add mod ord modGraphic">
          <ac:chgData name="美紀 織田" userId="9572cbd499a75355" providerId="LiveId" clId="{65565713-7EE2-4C12-9F19-1EC6598428A5}" dt="2024-06-04T07:39:09.040" v="724" actId="207"/>
          <ac:graphicFrameMkLst>
            <pc:docMk/>
            <pc:sldMk cId="493461597" sldId="257"/>
            <ac:graphicFrameMk id="2" creationId="{96158572-DF8A-DF0B-E2D0-65F5F4F0B093}"/>
          </ac:graphicFrameMkLst>
        </pc:graphicFrameChg>
        <pc:graphicFrameChg chg="del">
          <ac:chgData name="美紀 織田" userId="9572cbd499a75355" providerId="LiveId" clId="{65565713-7EE2-4C12-9F19-1EC6598428A5}" dt="2024-06-04T04:02:39.704" v="1" actId="478"/>
          <ac:graphicFrameMkLst>
            <pc:docMk/>
            <pc:sldMk cId="493461597" sldId="257"/>
            <ac:graphicFrameMk id="4" creationId="{F8114F3B-5E9F-9332-C11F-8BA732CF61B1}"/>
          </ac:graphicFrameMkLst>
        </pc:graphicFrameChg>
        <pc:graphicFrameChg chg="modGraphic">
          <ac:chgData name="美紀 織田" userId="9572cbd499a75355" providerId="LiveId" clId="{65565713-7EE2-4C12-9F19-1EC6598428A5}" dt="2024-06-04T07:39:13.136" v="725" actId="207"/>
          <ac:graphicFrameMkLst>
            <pc:docMk/>
            <pc:sldMk cId="493461597" sldId="257"/>
            <ac:graphicFrameMk id="5" creationId="{3D3CA74C-FF90-58E3-5AAB-3835D01A178F}"/>
          </ac:graphicFrameMkLst>
        </pc:graphicFrameChg>
        <pc:graphicFrameChg chg="modGraphic">
          <ac:chgData name="美紀 織田" userId="9572cbd499a75355" providerId="LiveId" clId="{65565713-7EE2-4C12-9F19-1EC6598428A5}" dt="2024-06-04T07:39:05.071" v="723" actId="207"/>
          <ac:graphicFrameMkLst>
            <pc:docMk/>
            <pc:sldMk cId="493461597" sldId="257"/>
            <ac:graphicFrameMk id="6" creationId="{CCA67E21-679C-CDD7-634A-A7C57607838D}"/>
          </ac:graphicFrameMkLst>
        </pc:graphicFrameChg>
        <pc:graphicFrameChg chg="modGraphic">
          <ac:chgData name="美紀 織田" userId="9572cbd499a75355" providerId="LiveId" clId="{65565713-7EE2-4C12-9F19-1EC6598428A5}" dt="2024-06-04T07:38:50.114" v="720" actId="207"/>
          <ac:graphicFrameMkLst>
            <pc:docMk/>
            <pc:sldMk cId="493461597" sldId="257"/>
            <ac:graphicFrameMk id="7" creationId="{1AB00137-A940-C7BB-4927-B6820D2865F5}"/>
          </ac:graphicFrameMkLst>
        </pc:graphicFrameChg>
        <pc:graphicFrameChg chg="mod modGraphic">
          <ac:chgData name="美紀 織田" userId="9572cbd499a75355" providerId="LiveId" clId="{65565713-7EE2-4C12-9F19-1EC6598428A5}" dt="2024-06-04T07:38:54.622" v="721" actId="207"/>
          <ac:graphicFrameMkLst>
            <pc:docMk/>
            <pc:sldMk cId="493461597" sldId="257"/>
            <ac:graphicFrameMk id="8" creationId="{BC471F31-4ED4-D751-6A92-2E67BE4C633F}"/>
          </ac:graphicFrameMkLst>
        </pc:graphicFrameChg>
        <pc:graphicFrameChg chg="modGraphic">
          <ac:chgData name="美紀 織田" userId="9572cbd499a75355" providerId="LiveId" clId="{65565713-7EE2-4C12-9F19-1EC6598428A5}" dt="2024-06-04T07:38:58.196" v="722" actId="207"/>
          <ac:graphicFrameMkLst>
            <pc:docMk/>
            <pc:sldMk cId="493461597" sldId="257"/>
            <ac:graphicFrameMk id="10" creationId="{4D805ECB-F5BA-6588-DD37-50F12FBF0E6E}"/>
          </ac:graphicFrameMkLst>
        </pc:graphicFrameChg>
      </pc:sldChg>
      <pc:sldChg chg="addSp delSp modSp new mod ord setBg modShow">
        <pc:chgData name="美紀 織田" userId="9572cbd499a75355" providerId="LiveId" clId="{65565713-7EE2-4C12-9F19-1EC6598428A5}" dt="2024-06-04T08:15:48.346" v="847" actId="14734"/>
        <pc:sldMkLst>
          <pc:docMk/>
          <pc:sldMk cId="3938240424" sldId="258"/>
        </pc:sldMkLst>
        <pc:spChg chg="del">
          <ac:chgData name="美紀 織田" userId="9572cbd499a75355" providerId="LiveId" clId="{65565713-7EE2-4C12-9F19-1EC6598428A5}" dt="2024-06-04T04:48:46.372" v="95" actId="478"/>
          <ac:spMkLst>
            <pc:docMk/>
            <pc:sldMk cId="3938240424" sldId="258"/>
            <ac:spMk id="2" creationId="{C2EEFA2E-B49D-FC99-F3FC-45F5BD6CC9F8}"/>
          </ac:spMkLst>
        </pc:spChg>
        <pc:spChg chg="del">
          <ac:chgData name="美紀 織田" userId="9572cbd499a75355" providerId="LiveId" clId="{65565713-7EE2-4C12-9F19-1EC6598428A5}" dt="2024-06-04T04:48:47.988" v="96" actId="478"/>
          <ac:spMkLst>
            <pc:docMk/>
            <pc:sldMk cId="3938240424" sldId="258"/>
            <ac:spMk id="3" creationId="{B5B5B21E-5FB8-5F5F-A959-1EBB0D631962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9" creationId="{F3060C83-F051-4F0E-ABAD-AA0DFC48B218}"/>
          </ac:spMkLst>
        </pc:spChg>
        <pc:spChg chg="add del">
          <ac:chgData name="美紀 織田" userId="9572cbd499a75355" providerId="LiveId" clId="{65565713-7EE2-4C12-9F19-1EC6598428A5}" dt="2024-06-04T04:49:08.687" v="103" actId="26606"/>
          <ac:spMkLst>
            <pc:docMk/>
            <pc:sldMk cId="3938240424" sldId="258"/>
            <ac:spMk id="10" creationId="{86FF76B9-219D-4469-AF87-0236D29032F1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11" creationId="{83C98ABE-055B-441F-B07E-44F97F083C39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13" creationId="{29FDB030-9B49-4CED-8CCD-4D99382388AC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15" creationId="{3783CA14-24A1-485C-8B30-D6A5D87987AD}"/>
          </ac:spMkLst>
        </pc:spChg>
        <pc:spChg chg="add del">
          <ac:chgData name="美紀 織田" userId="9572cbd499a75355" providerId="LiveId" clId="{65565713-7EE2-4C12-9F19-1EC6598428A5}" dt="2024-06-04T04:49:08.687" v="103" actId="26606"/>
          <ac:spMkLst>
            <pc:docMk/>
            <pc:sldMk cId="3938240424" sldId="258"/>
            <ac:spMk id="16" creationId="{2E80C965-DB6D-4F81-9E9E-B027384D0BD6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17" creationId="{9A97C86A-04D6-40F7-AE84-31AB43E6A846}"/>
          </ac:spMkLst>
        </pc:spChg>
        <pc:spChg chg="add del">
          <ac:chgData name="美紀 織田" userId="9572cbd499a75355" providerId="LiveId" clId="{65565713-7EE2-4C12-9F19-1EC6598428A5}" dt="2024-06-04T04:49:08.687" v="103" actId="26606"/>
          <ac:spMkLst>
            <pc:docMk/>
            <pc:sldMk cId="3938240424" sldId="258"/>
            <ac:spMk id="18" creationId="{633C5E46-DAC5-4661-9C87-22B08E2A512F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19" creationId="{FF9F2414-84E8-453E-B1F3-389FDE8192D9}"/>
          </ac:spMkLst>
        </pc:spChg>
        <pc:spChg chg="add del">
          <ac:chgData name="美紀 織田" userId="9572cbd499a75355" providerId="LiveId" clId="{65565713-7EE2-4C12-9F19-1EC6598428A5}" dt="2024-06-04T04:48:56.778" v="99" actId="26606"/>
          <ac:spMkLst>
            <pc:docMk/>
            <pc:sldMk cId="3938240424" sldId="258"/>
            <ac:spMk id="21" creationId="{3ECA69A1-7536-43AC-85EF-C7106179F5ED}"/>
          </ac:spMkLst>
        </pc:spChg>
        <pc:grpChg chg="add del">
          <ac:chgData name="美紀 織田" userId="9572cbd499a75355" providerId="LiveId" clId="{65565713-7EE2-4C12-9F19-1EC6598428A5}" dt="2024-06-04T04:49:08.687" v="103" actId="26606"/>
          <ac:grpSpMkLst>
            <pc:docMk/>
            <pc:sldMk cId="3938240424" sldId="258"/>
            <ac:grpSpMk id="12" creationId="{DB88BD78-87E1-424D-B479-C37D8E41B12E}"/>
          </ac:grpSpMkLst>
        </pc:grpChg>
        <pc:graphicFrameChg chg="add del mod">
          <ac:chgData name="美紀 織田" userId="9572cbd499a75355" providerId="LiveId" clId="{65565713-7EE2-4C12-9F19-1EC6598428A5}" dt="2024-06-04T04:49:03.243" v="100" actId="478"/>
          <ac:graphicFrameMkLst>
            <pc:docMk/>
            <pc:sldMk cId="3938240424" sldId="258"/>
            <ac:graphicFrameMk id="4" creationId="{5677499B-DFB8-8225-C494-DB404FDC3A22}"/>
          </ac:graphicFrameMkLst>
        </pc:graphicFrameChg>
        <pc:graphicFrameChg chg="add mod">
          <ac:chgData name="美紀 織田" userId="9572cbd499a75355" providerId="LiveId" clId="{65565713-7EE2-4C12-9F19-1EC6598428A5}" dt="2024-06-04T04:49:08.687" v="103" actId="26606"/>
          <ac:graphicFrameMkLst>
            <pc:docMk/>
            <pc:sldMk cId="3938240424" sldId="258"/>
            <ac:graphicFrameMk id="5" creationId="{BFA79230-4A3B-8293-C877-3DD7FDE586BA}"/>
          </ac:graphicFrameMkLst>
        </pc:graphicFrameChg>
        <pc:graphicFrameChg chg="add mod">
          <ac:chgData name="美紀 織田" userId="9572cbd499a75355" providerId="LiveId" clId="{65565713-7EE2-4C12-9F19-1EC6598428A5}" dt="2024-06-04T04:49:12.081" v="104"/>
          <ac:graphicFrameMkLst>
            <pc:docMk/>
            <pc:sldMk cId="3938240424" sldId="258"/>
            <ac:graphicFrameMk id="6" creationId="{4F41E899-BE98-A0B3-AE77-1273B66E0B6A}"/>
          </ac:graphicFrameMkLst>
        </pc:graphicFrameChg>
        <pc:graphicFrameChg chg="add mod modGraphic">
          <ac:chgData name="美紀 織田" userId="9572cbd499a75355" providerId="LiveId" clId="{65565713-7EE2-4C12-9F19-1EC6598428A5}" dt="2024-06-04T06:46:56.518" v="540" actId="255"/>
          <ac:graphicFrameMkLst>
            <pc:docMk/>
            <pc:sldMk cId="3938240424" sldId="258"/>
            <ac:graphicFrameMk id="8" creationId="{BAF14D60-5D8D-3834-7323-7541DF4F4E9D}"/>
          </ac:graphicFrameMkLst>
        </pc:graphicFrameChg>
        <pc:graphicFrameChg chg="add mod">
          <ac:chgData name="美紀 織田" userId="9572cbd499a75355" providerId="LiveId" clId="{65565713-7EE2-4C12-9F19-1EC6598428A5}" dt="2024-06-04T05:04:59.101" v="163"/>
          <ac:graphicFrameMkLst>
            <pc:docMk/>
            <pc:sldMk cId="3938240424" sldId="258"/>
            <ac:graphicFrameMk id="20" creationId="{09C20936-A008-CFBD-05EA-1E616D729E83}"/>
          </ac:graphicFrameMkLst>
        </pc:graphicFrameChg>
        <pc:graphicFrameChg chg="add mod modGraphic">
          <ac:chgData name="美紀 織田" userId="9572cbd499a75355" providerId="LiveId" clId="{65565713-7EE2-4C12-9F19-1EC6598428A5}" dt="2024-06-04T06:50:53.084" v="541" actId="14100"/>
          <ac:graphicFrameMkLst>
            <pc:docMk/>
            <pc:sldMk cId="3938240424" sldId="258"/>
            <ac:graphicFrameMk id="22" creationId="{75B33853-765D-033E-A779-11198368696E}"/>
          </ac:graphicFrameMkLst>
        </pc:graphicFrameChg>
        <pc:graphicFrameChg chg="add mod">
          <ac:chgData name="美紀 織田" userId="9572cbd499a75355" providerId="LiveId" clId="{65565713-7EE2-4C12-9F19-1EC6598428A5}" dt="2024-06-04T06:39:37.005" v="495"/>
          <ac:graphicFrameMkLst>
            <pc:docMk/>
            <pc:sldMk cId="3938240424" sldId="258"/>
            <ac:graphicFrameMk id="23" creationId="{E5A669B6-B820-54AC-2CD5-6B598D62B223}"/>
          </ac:graphicFrameMkLst>
        </pc:graphicFrameChg>
        <pc:graphicFrameChg chg="add mod modGraphic">
          <ac:chgData name="美紀 織田" userId="9572cbd499a75355" providerId="LiveId" clId="{65565713-7EE2-4C12-9F19-1EC6598428A5}" dt="2024-06-04T08:15:48.346" v="847" actId="14734"/>
          <ac:graphicFrameMkLst>
            <pc:docMk/>
            <pc:sldMk cId="3938240424" sldId="258"/>
            <ac:graphicFrameMk id="24" creationId="{781B3754-0FC3-2ECF-FB26-FC0228332DD3}"/>
          </ac:graphicFrameMkLst>
        </pc:graphicFrameChg>
      </pc:sldChg>
      <pc:sldChg chg="addSp delSp modSp new mod">
        <pc:chgData name="美紀 織田" userId="9572cbd499a75355" providerId="LiveId" clId="{65565713-7EE2-4C12-9F19-1EC6598428A5}" dt="2024-06-04T08:29:11.732" v="1127" actId="20577"/>
        <pc:sldMkLst>
          <pc:docMk/>
          <pc:sldMk cId="159367960" sldId="259"/>
        </pc:sldMkLst>
        <pc:spChg chg="add mod">
          <ac:chgData name="美紀 織田" userId="9572cbd499a75355" providerId="LiveId" clId="{65565713-7EE2-4C12-9F19-1EC6598428A5}" dt="2024-06-04T08:28:01.731" v="1088" actId="20577"/>
          <ac:spMkLst>
            <pc:docMk/>
            <pc:sldMk cId="159367960" sldId="259"/>
            <ac:spMk id="2" creationId="{0411F6D7-4982-1079-A7B5-881F248063EA}"/>
          </ac:spMkLst>
        </pc:spChg>
        <pc:spChg chg="del">
          <ac:chgData name="美紀 織田" userId="9572cbd499a75355" providerId="LiveId" clId="{65565713-7EE2-4C12-9F19-1EC6598428A5}" dt="2024-06-04T06:23:44.062" v="192" actId="478"/>
          <ac:spMkLst>
            <pc:docMk/>
            <pc:sldMk cId="159367960" sldId="259"/>
            <ac:spMk id="2" creationId="{4EEBEF78-7973-EB7B-B015-1AF4AA692CCD}"/>
          </ac:spMkLst>
        </pc:spChg>
        <pc:spChg chg="add mod">
          <ac:chgData name="美紀 織田" userId="9572cbd499a75355" providerId="LiveId" clId="{65565713-7EE2-4C12-9F19-1EC6598428A5}" dt="2024-06-04T08:28:24.675" v="1098" actId="1076"/>
          <ac:spMkLst>
            <pc:docMk/>
            <pc:sldMk cId="159367960" sldId="259"/>
            <ac:spMk id="3" creationId="{4B421497-AA6C-1DCF-B8B2-8711CD0DCA02}"/>
          </ac:spMkLst>
        </pc:spChg>
        <pc:spChg chg="del">
          <ac:chgData name="美紀 織田" userId="9572cbd499a75355" providerId="LiveId" clId="{65565713-7EE2-4C12-9F19-1EC6598428A5}" dt="2024-06-04T06:23:45.514" v="193" actId="478"/>
          <ac:spMkLst>
            <pc:docMk/>
            <pc:sldMk cId="159367960" sldId="259"/>
            <ac:spMk id="3" creationId="{CA9CD79D-6A3A-2A0E-A8A5-6340FA8FC0D8}"/>
          </ac:spMkLst>
        </pc:spChg>
        <pc:spChg chg="add mod">
          <ac:chgData name="美紀 織田" userId="9572cbd499a75355" providerId="LiveId" clId="{65565713-7EE2-4C12-9F19-1EC6598428A5}" dt="2024-06-04T08:28:20.022" v="1097" actId="1076"/>
          <ac:spMkLst>
            <pc:docMk/>
            <pc:sldMk cId="159367960" sldId="259"/>
            <ac:spMk id="6" creationId="{3B786513-5BF3-6E80-85B1-51B1A895E58E}"/>
          </ac:spMkLst>
        </pc:spChg>
        <pc:spChg chg="add del">
          <ac:chgData name="美紀 織田" userId="9572cbd499a75355" providerId="LiveId" clId="{65565713-7EE2-4C12-9F19-1EC6598428A5}" dt="2024-06-04T06:29:07.225" v="235" actId="22"/>
          <ac:spMkLst>
            <pc:docMk/>
            <pc:sldMk cId="159367960" sldId="259"/>
            <ac:spMk id="7" creationId="{34053194-A33D-8860-D077-72E76141E2E6}"/>
          </ac:spMkLst>
        </pc:spChg>
        <pc:spChg chg="add mod">
          <ac:chgData name="美紀 織田" userId="9572cbd499a75355" providerId="LiveId" clId="{65565713-7EE2-4C12-9F19-1EC6598428A5}" dt="2024-06-04T08:28:13.303" v="1096" actId="20577"/>
          <ac:spMkLst>
            <pc:docMk/>
            <pc:sldMk cId="159367960" sldId="259"/>
            <ac:spMk id="7" creationId="{406F8FA4-B231-70C7-4B6A-F3C012CE7E9B}"/>
          </ac:spMkLst>
        </pc:spChg>
        <pc:spChg chg="add mod">
          <ac:chgData name="美紀 織田" userId="9572cbd499a75355" providerId="LiveId" clId="{65565713-7EE2-4C12-9F19-1EC6598428A5}" dt="2024-06-04T08:29:08.674" v="1123" actId="20577"/>
          <ac:spMkLst>
            <pc:docMk/>
            <pc:sldMk cId="159367960" sldId="259"/>
            <ac:spMk id="8" creationId="{0E3650A6-3D4F-8365-0030-879BCE5635CE}"/>
          </ac:spMkLst>
        </pc:spChg>
        <pc:spChg chg="add mod">
          <ac:chgData name="美紀 織田" userId="9572cbd499a75355" providerId="LiveId" clId="{65565713-7EE2-4C12-9F19-1EC6598428A5}" dt="2024-06-04T07:27:59.753" v="673" actId="1076"/>
          <ac:spMkLst>
            <pc:docMk/>
            <pc:sldMk cId="159367960" sldId="259"/>
            <ac:spMk id="9" creationId="{A6C9860D-2D77-479C-2059-535EC1C138EA}"/>
          </ac:spMkLst>
        </pc:spChg>
        <pc:spChg chg="add mod">
          <ac:chgData name="美紀 織田" userId="9572cbd499a75355" providerId="LiveId" clId="{65565713-7EE2-4C12-9F19-1EC6598428A5}" dt="2024-06-04T08:29:11.732" v="1127" actId="20577"/>
          <ac:spMkLst>
            <pc:docMk/>
            <pc:sldMk cId="159367960" sldId="259"/>
            <ac:spMk id="10" creationId="{A6525E08-E2C9-3903-4008-533B190BB769}"/>
          </ac:spMkLst>
        </pc:spChg>
        <pc:spChg chg="add mod">
          <ac:chgData name="美紀 織田" userId="9572cbd499a75355" providerId="LiveId" clId="{65565713-7EE2-4C12-9F19-1EC6598428A5}" dt="2024-06-04T07:27:59.753" v="673" actId="1076"/>
          <ac:spMkLst>
            <pc:docMk/>
            <pc:sldMk cId="159367960" sldId="259"/>
            <ac:spMk id="11" creationId="{74CCE912-CBA9-9B7A-80DF-F31E0D400534}"/>
          </ac:spMkLst>
        </pc:spChg>
        <pc:spChg chg="add mod">
          <ac:chgData name="美紀 織田" userId="9572cbd499a75355" providerId="LiveId" clId="{65565713-7EE2-4C12-9F19-1EC6598428A5}" dt="2024-06-04T07:27:59.753" v="673" actId="1076"/>
          <ac:spMkLst>
            <pc:docMk/>
            <pc:sldMk cId="159367960" sldId="259"/>
            <ac:spMk id="12" creationId="{D92BDEF6-EFCB-6B5B-25E2-A49BF6FED3DC}"/>
          </ac:spMkLst>
        </pc:spChg>
        <pc:spChg chg="add mod">
          <ac:chgData name="美紀 織田" userId="9572cbd499a75355" providerId="LiveId" clId="{65565713-7EE2-4C12-9F19-1EC6598428A5}" dt="2024-06-04T07:27:59.753" v="673" actId="1076"/>
          <ac:spMkLst>
            <pc:docMk/>
            <pc:sldMk cId="159367960" sldId="259"/>
            <ac:spMk id="13" creationId="{0B6E005B-252B-C7F0-A9A0-3D6CB3238CE8}"/>
          </ac:spMkLst>
        </pc:spChg>
        <pc:graphicFrameChg chg="add del mod modGraphic">
          <ac:chgData name="美紀 織田" userId="9572cbd499a75355" providerId="LiveId" clId="{65565713-7EE2-4C12-9F19-1EC6598428A5}" dt="2024-06-04T07:27:59.753" v="673" actId="1076"/>
          <ac:graphicFrameMkLst>
            <pc:docMk/>
            <pc:sldMk cId="159367960" sldId="259"/>
            <ac:graphicFrameMk id="4" creationId="{E99FF7C0-B906-79CE-12CA-8099F6D34BB4}"/>
          </ac:graphicFrameMkLst>
        </pc:graphicFrameChg>
        <pc:graphicFrameChg chg="add mod modGraphic">
          <ac:chgData name="美紀 織田" userId="9572cbd499a75355" providerId="LiveId" clId="{65565713-7EE2-4C12-9F19-1EC6598428A5}" dt="2024-06-04T07:27:59.753" v="673" actId="1076"/>
          <ac:graphicFrameMkLst>
            <pc:docMk/>
            <pc:sldMk cId="159367960" sldId="259"/>
            <ac:graphicFrameMk id="5" creationId="{9D334D6D-FC5C-3986-6E09-E94D92C8CF7E}"/>
          </ac:graphicFrameMkLst>
        </pc:graphicFrameChg>
        <pc:graphicFrameChg chg="add mod">
          <ac:chgData name="美紀 織田" userId="9572cbd499a75355" providerId="LiveId" clId="{65565713-7EE2-4C12-9F19-1EC6598428A5}" dt="2024-06-04T06:39:19.121" v="491"/>
          <ac:graphicFrameMkLst>
            <pc:docMk/>
            <pc:sldMk cId="159367960" sldId="259"/>
            <ac:graphicFrameMk id="14" creationId="{C8F7B0C3-02D9-18D7-A6E1-9AC2253032B9}"/>
          </ac:graphicFrameMkLst>
        </pc:graphicFrameChg>
      </pc:sldChg>
      <pc:sldChg chg="delSp add mod">
        <pc:chgData name="美紀 織田" userId="9572cbd499a75355" providerId="LiveId" clId="{65565713-7EE2-4C12-9F19-1EC6598428A5}" dt="2024-06-04T08:14:17.296" v="844" actId="478"/>
        <pc:sldMkLst>
          <pc:docMk/>
          <pc:sldMk cId="2650453976" sldId="273"/>
        </pc:sldMkLst>
        <pc:spChg chg="del">
          <ac:chgData name="美紀 織田" userId="9572cbd499a75355" providerId="LiveId" clId="{65565713-7EE2-4C12-9F19-1EC6598428A5}" dt="2024-06-04T08:14:17.296" v="844" actId="478"/>
          <ac:spMkLst>
            <pc:docMk/>
            <pc:sldMk cId="2650453976" sldId="273"/>
            <ac:spMk id="10" creationId="{ACE624AB-32D8-0316-831F-362A8D3F91B9}"/>
          </ac:spMkLst>
        </pc:spChg>
      </pc:sldChg>
      <pc:sldChg chg="delSp modSp add mod">
        <pc:chgData name="美紀 織田" userId="9572cbd499a75355" providerId="LiveId" clId="{65565713-7EE2-4C12-9F19-1EC6598428A5}" dt="2024-06-04T08:14:19.827" v="845" actId="478"/>
        <pc:sldMkLst>
          <pc:docMk/>
          <pc:sldMk cId="1939916627" sldId="274"/>
        </pc:sldMkLst>
        <pc:spChg chg="mod">
          <ac:chgData name="美紀 織田" userId="9572cbd499a75355" providerId="LiveId" clId="{65565713-7EE2-4C12-9F19-1EC6598428A5}" dt="2024-06-04T07:23:15.894" v="561" actId="1076"/>
          <ac:spMkLst>
            <pc:docMk/>
            <pc:sldMk cId="1939916627" sldId="274"/>
            <ac:spMk id="8" creationId="{A3A1FC54-1843-1259-4077-63B272EA4C85}"/>
          </ac:spMkLst>
        </pc:spChg>
        <pc:spChg chg="del">
          <ac:chgData name="美紀 織田" userId="9572cbd499a75355" providerId="LiveId" clId="{65565713-7EE2-4C12-9F19-1EC6598428A5}" dt="2024-06-04T08:14:19.827" v="845" actId="478"/>
          <ac:spMkLst>
            <pc:docMk/>
            <pc:sldMk cId="1939916627" sldId="274"/>
            <ac:spMk id="10" creationId="{ACE624AB-32D8-0316-831F-362A8D3F91B9}"/>
          </ac:spMkLst>
        </pc:spChg>
      </pc:sldChg>
    </pc:docChg>
  </pc:docChgLst>
</pc:chgInfo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NULL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NULL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NULL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NULL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NULL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NULL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9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1</cx:pt>
          <cx:pt idx="45">1</cx:pt>
          <cx:pt idx="46">1</cx:pt>
          <cx:pt idx="47">1</cx:pt>
          <cx:pt idx="48">1</cx:pt>
        </cx:lvl>
      </cx:strDim>
      <cx:numDim type="val">
        <cx:lvl ptCount="49" formatCode="General">
          <cx:pt idx="0">4</cx:pt>
          <cx:pt idx="1">2</cx:pt>
          <cx:pt idx="2">8</cx:pt>
          <cx:pt idx="3">8</cx:pt>
          <cx:pt idx="4">14</cx:pt>
          <cx:pt idx="5">11</cx:pt>
          <cx:pt idx="6">11</cx:pt>
          <cx:pt idx="7">3</cx:pt>
          <cx:pt idx="8">7</cx:pt>
          <cx:pt idx="9">12</cx:pt>
          <cx:pt idx="10">28</cx:pt>
          <cx:pt idx="11">13</cx:pt>
          <cx:pt idx="12">3</cx:pt>
          <cx:pt idx="13">16</cx:pt>
          <cx:pt idx="14">17</cx:pt>
          <cx:pt idx="15">13</cx:pt>
          <cx:pt idx="16">12</cx:pt>
          <cx:pt idx="17">14</cx:pt>
          <cx:pt idx="18">1</cx:pt>
          <cx:pt idx="19">10</cx:pt>
          <cx:pt idx="20">2</cx:pt>
          <cx:pt idx="21">1</cx:pt>
          <cx:pt idx="22">6</cx:pt>
          <cx:pt idx="23">10</cx:pt>
          <cx:pt idx="24">16</cx:pt>
          <cx:pt idx="25">10</cx:pt>
          <cx:pt idx="26">19</cx:pt>
          <cx:pt idx="27">14</cx:pt>
          <cx:pt idx="28">8</cx:pt>
          <cx:pt idx="29">5</cx:pt>
          <cx:pt idx="30">9</cx:pt>
          <cx:pt idx="31">10</cx:pt>
          <cx:pt idx="32">6</cx:pt>
          <cx:pt idx="33">7</cx:pt>
          <cx:pt idx="34">8</cx:pt>
          <cx:pt idx="35">5</cx:pt>
          <cx:pt idx="36">12</cx:pt>
          <cx:pt idx="37">3</cx:pt>
          <cx:pt idx="38">7</cx:pt>
          <cx:pt idx="39">9</cx:pt>
          <cx:pt idx="40">10</cx:pt>
          <cx:pt idx="41">6</cx:pt>
          <cx:pt idx="42">11</cx:pt>
          <cx:pt idx="43">4</cx:pt>
          <cx:pt idx="44">15</cx:pt>
          <cx:pt idx="45">12</cx:pt>
          <cx:pt idx="46">12</cx:pt>
          <cx:pt idx="47">30</cx:pt>
          <cx:pt idx="48">23</cx:pt>
        </cx:lvl>
      </cx:numDim>
    </cx:data>
  </cx:chartData>
  <cx:chart>
    <cx:title pos="t" align="ctr" overlay="0">
      <cx:tx>
        <cx:rich>
          <a:bodyPr spcFirstLastPara="1" vertOverflow="ellipsis" wrap="square" lIns="0" tIns="0" rIns="0" bIns="0" anchor="ctr" anchorCtr="1"/>
          <a:lstStyle/>
          <a:p>
            <a:pPr algn="ctr">
              <a:defRPr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r>
              <a:rPr lang="en-US" altLang="ja-JP" baseline="0" dirty="0">
                <a:solidFill>
                  <a:schemeClr val="tx1"/>
                </a:solidFill>
                <a:latin typeface="Palatino Linotype" panose="02040502050505030304" pitchFamily="18" charset="0"/>
              </a:rPr>
              <a:t>ICU stay</a:t>
            </a:r>
            <a:endParaRPr lang="en-US" baseline="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cx:rich>
      </cx:tx>
    </cx:title>
    <cx:plotArea>
      <cx:plotAreaRegion>
        <cx:series layoutId="boxWhisker" uniqueId="{4182C088-BBF1-40C3-8A6B-46B290DE937D}">
          <cx:spPr>
            <a:solidFill>
              <a:schemeClr val="bg1"/>
            </a:solidFill>
            <a:ln w="6350">
              <a:solidFill>
                <a:schemeClr val="tx1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rgbClr val="595959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latin typeface="Palatino Linotype" panose="0204050205050503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solidFill>
                <a:schemeClr val="tx1"/>
              </a:solidFill>
              <a:latin typeface="Palatino Linotype" panose="02040502050505030304" pitchFamily="18" charset="0"/>
            </a:endParaRPr>
          </a:p>
        </cx:txPr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7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1</cx:pt>
          <cx:pt idx="43">1</cx:pt>
          <cx:pt idx="44">1</cx:pt>
          <cx:pt idx="45">1</cx:pt>
          <cx:pt idx="46">1</cx:pt>
        </cx:lvl>
      </cx:strDim>
      <cx:numDim type="val">
        <cx:lvl ptCount="47" formatCode="General">
          <cx:pt idx="0">9217</cx:pt>
          <cx:pt idx="1">5594</cx:pt>
          <cx:pt idx="2">4012</cx:pt>
          <cx:pt idx="3">3943</cx:pt>
          <cx:pt idx="4">3405</cx:pt>
          <cx:pt idx="5">6266</cx:pt>
          <cx:pt idx="6">6400</cx:pt>
          <cx:pt idx="7">7282</cx:pt>
          <cx:pt idx="8">3346</cx:pt>
          <cx:pt idx="9">4806</cx:pt>
          <cx:pt idx="10">6800</cx:pt>
          <cx:pt idx="11">6422</cx:pt>
          <cx:pt idx="12">3964</cx:pt>
          <cx:pt idx="13">3293</cx:pt>
          <cx:pt idx="14">4000</cx:pt>
          <cx:pt idx="15">4764</cx:pt>
          <cx:pt idx="16">6402</cx:pt>
          <cx:pt idx="17">11637</cx:pt>
          <cx:pt idx="18">9461</cx:pt>
          <cx:pt idx="19">13107</cx:pt>
          <cx:pt idx="20">7433</cx:pt>
          <cx:pt idx="21">7321</cx:pt>
          <cx:pt idx="22">3265</cx:pt>
          <cx:pt idx="23">5295</cx:pt>
          <cx:pt idx="24">9803</cx:pt>
          <cx:pt idx="25">6372</cx:pt>
          <cx:pt idx="26">5139</cx:pt>
          <cx:pt idx="27">9718</cx:pt>
          <cx:pt idx="28">5550</cx:pt>
          <cx:pt idx="29">4815</cx:pt>
          <cx:pt idx="30">9217.7999999999993</cx:pt>
          <cx:pt idx="31">7450</cx:pt>
          <cx:pt idx="32">3820</cx:pt>
          <cx:pt idx="33">3552</cx:pt>
          <cx:pt idx="34">6007</cx:pt>
          <cx:pt idx="35">7502</cx:pt>
          <cx:pt idx="36">6506</cx:pt>
          <cx:pt idx="37">6213</cx:pt>
          <cx:pt idx="38">5550</cx:pt>
          <cx:pt idx="39">6298</cx:pt>
          <cx:pt idx="40">4884</cx:pt>
          <cx:pt idx="41">10108</cx:pt>
          <cx:pt idx="42">4770</cx:pt>
          <cx:pt idx="43">6834</cx:pt>
          <cx:pt idx="44">6456</cx:pt>
          <cx:pt idx="45">6234</cx:pt>
          <cx:pt idx="46">4049</cx:pt>
        </cx:lvl>
      </cx:numDim>
    </cx:data>
  </cx:chartData>
  <cx:chart>
    <cx:title pos="t" align="ctr" overlay="0">
      <cx:tx>
        <cx:rich>
          <a:bodyPr spcFirstLastPara="1" vertOverflow="ellipsis" wrap="square" lIns="0" tIns="0" rIns="0" bIns="0" anchor="ctr" anchorCtr="1"/>
          <a:lstStyle/>
          <a:p>
            <a:pPr marL="0" algn="ctr" rtl="0" eaLnBrk="1" fontAlgn="ctr" latinLnBrk="0" hangingPunct="1">
              <a:spcBef>
                <a:spcPts val="0"/>
              </a:spcBef>
              <a:spcAft>
                <a:spcPts val="0"/>
              </a:spcAft>
              <a:defRPr sz="1400"/>
            </a:pPr>
            <a:r>
              <a:rPr kumimoji="1" lang="en-US" altLang="ja-JP" sz="1400" b="0" i="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</a:rPr>
              <a:t>E</a:t>
            </a:r>
            <a:r>
              <a:rPr kumimoji="1" lang="ja-JP" altLang="ja-JP" sz="1400" b="0" i="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</a:rPr>
              <a:t>nergy intake </a:t>
            </a:r>
            <a:r>
              <a:rPr kumimoji="1" lang="en-US" altLang="ja-JP" sz="1400" b="0" i="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 Linotype" panose="02040502050505030304" pitchFamily="18" charset="0"/>
              </a:rPr>
              <a:t>during 7 days</a:t>
            </a:r>
            <a:endParaRPr lang="ja-JP" altLang="ja-JP" sz="1400" dirty="0">
              <a:effectLst/>
            </a:endParaRPr>
          </a:p>
        </cx:rich>
      </cx:tx>
    </cx:title>
    <cx:plotArea>
      <cx:plotAreaRegion>
        <cx:series layoutId="boxWhisker" uniqueId="{4182C088-BBF1-40C3-8A6B-46B290DE937D}">
          <cx:spPr>
            <a:solidFill>
              <a:schemeClr val="bg1"/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rgbClr val="595959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latin typeface="Palatino Linotype" panose="02040502050505030304" pitchFamily="18" charset="0"/>
            </a:endParaRPr>
          </a:p>
        </cx:txPr>
      </cx:axis>
      <cx:axis id="1">
        <cx:valScaling min="2000"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solidFill>
                <a:schemeClr val="tx1"/>
              </a:solidFill>
              <a:latin typeface="Palatino Linotype" panose="02040502050505030304" pitchFamily="18" charset="0"/>
            </a:endParaRPr>
          </a:p>
        </cx:txPr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9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1</cx:pt>
          <cx:pt idx="45">1</cx:pt>
          <cx:pt idx="46">1</cx:pt>
          <cx:pt idx="47">1</cx:pt>
          <cx:pt idx="48">1</cx:pt>
        </cx:lvl>
      </cx:strDim>
      <cx:numDim type="val">
        <cx:lvl ptCount="49" formatCode="General">
          <cx:pt idx="0">9</cx:pt>
          <cx:pt idx="1">9</cx:pt>
          <cx:pt idx="2">17</cx:pt>
          <cx:pt idx="3">25</cx:pt>
          <cx:pt idx="4">34</cx:pt>
          <cx:pt idx="5">9</cx:pt>
          <cx:pt idx="6">25</cx:pt>
          <cx:pt idx="7">17</cx:pt>
          <cx:pt idx="8">9</cx:pt>
          <cx:pt idx="9">9</cx:pt>
          <cx:pt idx="10">36</cx:pt>
          <cx:pt idx="11">25</cx:pt>
          <cx:pt idx="12">9</cx:pt>
          <cx:pt idx="13">25</cx:pt>
          <cx:pt idx="14">35</cx:pt>
          <cx:pt idx="15">25</cx:pt>
          <cx:pt idx="16">26</cx:pt>
          <cx:pt idx="17">38</cx:pt>
          <cx:pt idx="18">9</cx:pt>
          <cx:pt idx="19">25</cx:pt>
          <cx:pt idx="20">9</cx:pt>
          <cx:pt idx="21">4</cx:pt>
          <cx:pt idx="22">9</cx:pt>
          <cx:pt idx="23">30</cx:pt>
          <cx:pt idx="24">26</cx:pt>
          <cx:pt idx="25">25</cx:pt>
          <cx:pt idx="26">16</cx:pt>
          <cx:pt idx="27">25</cx:pt>
          <cx:pt idx="28">22</cx:pt>
          <cx:pt idx="29">30</cx:pt>
          <cx:pt idx="30">16</cx:pt>
          <cx:pt idx="31">5</cx:pt>
          <cx:pt idx="32">16</cx:pt>
          <cx:pt idx="33">16</cx:pt>
          <cx:pt idx="34">16</cx:pt>
          <cx:pt idx="35">9</cx:pt>
          <cx:pt idx="36">16</cx:pt>
          <cx:pt idx="37">5</cx:pt>
          <cx:pt idx="38">18</cx:pt>
          <cx:pt idx="39">18</cx:pt>
          <cx:pt idx="40">10</cx:pt>
          <cx:pt idx="41">28</cx:pt>
          <cx:pt idx="42">17</cx:pt>
          <cx:pt idx="43">14</cx:pt>
          <cx:pt idx="44">8</cx:pt>
          <cx:pt idx="45">36</cx:pt>
          <cx:pt idx="46">38</cx:pt>
          <cx:pt idx="47">17</cx:pt>
          <cx:pt idx="48">37</cx:pt>
        </cx:lvl>
      </cx:numDim>
    </cx:data>
  </cx:chartData>
  <cx:chart>
    <cx:title pos="t" align="ctr" overlay="0">
      <cx:tx>
        <cx:txData>
          <cx:v>ISS </cx:v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>
              <a:solidFill>
                <a:schemeClr val="tx1"/>
              </a:solidFill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defRPr>
          </a:pPr>
          <a:r>
            <a:rPr lang="en-US" baseline="0" dirty="0">
              <a:solidFill>
                <a:schemeClr val="tx1"/>
              </a:solidFill>
              <a:latin typeface="Palatino Linotype" panose="02040502050505030304" pitchFamily="18" charset="0"/>
            </a:rPr>
            <a:t>ISS </a:t>
          </a:r>
        </a:p>
      </cx:txPr>
    </cx:title>
    <cx:plotArea>
      <cx:plotAreaRegion>
        <cx:series layoutId="boxWhisker" uniqueId="{4182C088-BBF1-40C3-8A6B-46B290DE937D}">
          <cx:spPr>
            <a:solidFill>
              <a:schemeClr val="bg1"/>
            </a:solidFill>
            <a:ln w="6350">
              <a:solidFill>
                <a:schemeClr val="tx1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rgbClr val="595959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latin typeface="Palatino Linotype" panose="0204050205050503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solidFill>
                <a:schemeClr val="tx1"/>
              </a:solidFill>
              <a:latin typeface="Palatino Linotype" panose="02040502050505030304" pitchFamily="18" charset="0"/>
            </a:endParaRPr>
          </a:p>
        </cx:txPr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9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1</cx:pt>
          <cx:pt idx="45">1</cx:pt>
          <cx:pt idx="46">1</cx:pt>
          <cx:pt idx="47">1</cx:pt>
          <cx:pt idx="48">1</cx:pt>
        </cx:lvl>
      </cx:strDim>
      <cx:numDim type="val">
        <cx:lvl ptCount="49" formatCode="General">
          <cx:pt idx="0">0</cx:pt>
          <cx:pt idx="1">1</cx:pt>
          <cx:pt idx="2">1</cx:pt>
          <cx:pt idx="3">1</cx:pt>
          <cx:pt idx="4">2</cx:pt>
          <cx:pt idx="5">0</cx:pt>
          <cx:pt idx="6">0</cx:pt>
          <cx:pt idx="7">2</cx:pt>
          <cx:pt idx="8">3</cx:pt>
          <cx:pt idx="9">1</cx:pt>
          <cx:pt idx="10">2</cx:pt>
          <cx:pt idx="11">2</cx:pt>
          <cx:pt idx="12">1</cx:pt>
          <cx:pt idx="13">0</cx:pt>
          <cx:pt idx="14">0</cx:pt>
          <cx:pt idx="15">3</cx:pt>
          <cx:pt idx="16">0</cx:pt>
          <cx:pt idx="17">1</cx:pt>
          <cx:pt idx="18">0</cx:pt>
          <cx:pt idx="19">4</cx:pt>
          <cx:pt idx="20">2</cx:pt>
          <cx:pt idx="21">1</cx:pt>
          <cx:pt idx="22">1</cx:pt>
          <cx:pt idx="23">4</cx:pt>
          <cx:pt idx="24">2</cx:pt>
          <cx:pt idx="25">1</cx:pt>
          <cx:pt idx="26">1</cx:pt>
          <cx:pt idx="27">2</cx:pt>
          <cx:pt idx="28">3</cx:pt>
          <cx:pt idx="29">4</cx:pt>
          <cx:pt idx="30">0</cx:pt>
          <cx:pt idx="31">0</cx:pt>
          <cx:pt idx="32">0</cx:pt>
          <cx:pt idx="33">3</cx:pt>
          <cx:pt idx="34">3</cx:pt>
          <cx:pt idx="35">2</cx:pt>
          <cx:pt idx="36">0</cx:pt>
          <cx:pt idx="37">1</cx:pt>
          <cx:pt idx="38">1</cx:pt>
          <cx:pt idx="39">0</cx:pt>
          <cx:pt idx="40">3</cx:pt>
          <cx:pt idx="41">0</cx:pt>
          <cx:pt idx="42">4</cx:pt>
          <cx:pt idx="43">0</cx:pt>
          <cx:pt idx="44">0</cx:pt>
          <cx:pt idx="45">2</cx:pt>
          <cx:pt idx="46">0</cx:pt>
          <cx:pt idx="47">2</cx:pt>
          <cx:pt idx="48">3</cx:pt>
        </cx:lvl>
      </cx:numDim>
    </cx:data>
  </cx:chartData>
  <cx:chart>
    <cx:title pos="t" align="ctr" overlay="0">
      <cx:tx>
        <cx:txData>
          <cx:v>CONUT at admission</cx:v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>
              <a:solidFill>
                <a:schemeClr val="tx1"/>
              </a:solidFill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defRPr>
          </a:pPr>
          <a:r>
            <a:rPr lang="en-US" baseline="0" dirty="0">
              <a:solidFill>
                <a:schemeClr val="tx1"/>
              </a:solidFill>
              <a:latin typeface="Palatino Linotype" panose="02040502050505030304" pitchFamily="18" charset="0"/>
            </a:rPr>
            <a:t>CONUT at admission</a:t>
          </a:r>
        </a:p>
      </cx:txPr>
    </cx:title>
    <cx:plotArea>
      <cx:plotAreaRegion>
        <cx:series layoutId="boxWhisker" uniqueId="{4182C088-BBF1-40C3-8A6B-46B290DE937D}">
          <cx:spPr>
            <a:solidFill>
              <a:schemeClr val="bg1"/>
            </a:solidFill>
            <a:ln w="6350">
              <a:solidFill>
                <a:schemeClr val="tx1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rgbClr val="595959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latin typeface="Palatino Linotype" panose="0204050205050503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solidFill>
                <a:schemeClr val="tx1"/>
              </a:solidFill>
              <a:latin typeface="Palatino Linotype" panose="02040502050505030304" pitchFamily="18" charset="0"/>
            </a:endParaRPr>
          </a:p>
        </cx:txPr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9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1</cx:pt>
          <cx:pt idx="45">1</cx:pt>
          <cx:pt idx="46">1</cx:pt>
          <cx:pt idx="47">1</cx:pt>
          <cx:pt idx="48">1</cx:pt>
        </cx:lvl>
      </cx:strDim>
      <cx:numDim type="val">
        <cx:lvl ptCount="49" formatCode="General">
          <cx:pt idx="0">4</cx:pt>
          <cx:pt idx="1">5</cx:pt>
          <cx:pt idx="2">1</cx:pt>
          <cx:pt idx="3">2</cx:pt>
          <cx:pt idx="4">7</cx:pt>
          <cx:pt idx="5">1</cx:pt>
          <cx:pt idx="6">9</cx:pt>
          <cx:pt idx="7">2</cx:pt>
          <cx:pt idx="8">6</cx:pt>
          <cx:pt idx="9">8</cx:pt>
          <cx:pt idx="10">10</cx:pt>
          <cx:pt idx="11">8</cx:pt>
          <cx:pt idx="12">3</cx:pt>
          <cx:pt idx="13">9</cx:pt>
          <cx:pt idx="14">6</cx:pt>
          <cx:pt idx="15">8</cx:pt>
          <cx:pt idx="16">4</cx:pt>
          <cx:pt idx="17">4</cx:pt>
          <cx:pt idx="18">2</cx:pt>
          <cx:pt idx="19">8</cx:pt>
          <cx:pt idx="20">3</cx:pt>
          <cx:pt idx="21">1</cx:pt>
          <cx:pt idx="22">7</cx:pt>
          <cx:pt idx="23">6</cx:pt>
          <cx:pt idx="24">10</cx:pt>
          <cx:pt idx="25">1</cx:pt>
          <cx:pt idx="26">0</cx:pt>
          <cx:pt idx="27">9</cx:pt>
          <cx:pt idx="28">3</cx:pt>
          <cx:pt idx="29">4</cx:pt>
          <cx:pt idx="30">2</cx:pt>
          <cx:pt idx="31">4</cx:pt>
          <cx:pt idx="32">0</cx:pt>
          <cx:pt idx="33">6</cx:pt>
          <cx:pt idx="34">5</cx:pt>
          <cx:pt idx="35">4</cx:pt>
          <cx:pt idx="36">4</cx:pt>
          <cx:pt idx="37">10</cx:pt>
          <cx:pt idx="38">3</cx:pt>
          <cx:pt idx="39">2</cx:pt>
          <cx:pt idx="40">5</cx:pt>
          <cx:pt idx="41">7</cx:pt>
          <cx:pt idx="42">9</cx:pt>
          <cx:pt idx="43">2</cx:pt>
          <cx:pt idx="44">2</cx:pt>
          <cx:pt idx="45">5</cx:pt>
          <cx:pt idx="46">7</cx:pt>
          <cx:pt idx="47">3</cx:pt>
          <cx:pt idx="48">10</cx:pt>
        </cx:lvl>
      </cx:numDim>
    </cx:data>
  </cx:chartData>
  <cx:chart>
    <cx:title pos="t" align="ctr" overlay="0">
      <cx:tx>
        <cx:txData>
          <cx:v>CONUT on day 7</cx:v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>
              <a:solidFill>
                <a:schemeClr val="tx1"/>
              </a:solidFill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defRPr>
          </a:pPr>
          <a:r>
            <a:rPr lang="en-US" baseline="0" dirty="0">
              <a:solidFill>
                <a:schemeClr val="tx1"/>
              </a:solidFill>
              <a:latin typeface="Palatino Linotype" panose="02040502050505030304" pitchFamily="18" charset="0"/>
            </a:rPr>
            <a:t>CONUT on day 7</a:t>
          </a:r>
        </a:p>
      </cx:txPr>
    </cx:title>
    <cx:plotArea>
      <cx:plotAreaRegion>
        <cx:series layoutId="boxWhisker" uniqueId="{4182C088-BBF1-40C3-8A6B-46B290DE937D}">
          <cx:spPr>
            <a:solidFill>
              <a:schemeClr val="bg1"/>
            </a:solidFill>
            <a:ln w="6350">
              <a:solidFill>
                <a:schemeClr val="tx1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rgbClr val="595959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latin typeface="Palatino Linotype" panose="0204050205050503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solidFill>
                <a:schemeClr val="tx1"/>
              </a:solidFill>
              <a:latin typeface="Palatino Linotype" panose="02040502050505030304" pitchFamily="18" charset="0"/>
            </a:endParaRPr>
          </a:p>
        </cx:txPr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9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1</cx:pt>
          <cx:pt idx="45">1</cx:pt>
          <cx:pt idx="46">1</cx:pt>
          <cx:pt idx="47">1</cx:pt>
          <cx:pt idx="48">1</cx:pt>
        </cx:lvl>
      </cx:strDim>
      <cx:numDim type="val">
        <cx:lvl ptCount="49" formatCode="General">
          <cx:pt idx="0">25</cx:pt>
          <cx:pt idx="1">19</cx:pt>
          <cx:pt idx="2">32</cx:pt>
          <cx:pt idx="3">42</cx:pt>
          <cx:pt idx="4">48</cx:pt>
          <cx:pt idx="5">24</cx:pt>
          <cx:pt idx="6">60</cx:pt>
          <cx:pt idx="7">12</cx:pt>
          <cx:pt idx="8">52</cx:pt>
          <cx:pt idx="9">57</cx:pt>
          <cx:pt idx="10">28</cx:pt>
          <cx:pt idx="11">63</cx:pt>
          <cx:pt idx="12">16</cx:pt>
          <cx:pt idx="13">56</cx:pt>
          <cx:pt idx="14">47</cx:pt>
          <cx:pt idx="15">33</cx:pt>
          <cx:pt idx="16">87</cx:pt>
          <cx:pt idx="17">35</cx:pt>
          <cx:pt idx="18">39</cx:pt>
          <cx:pt idx="19">10</cx:pt>
          <cx:pt idx="20">24</cx:pt>
          <cx:pt idx="21">17</cx:pt>
          <cx:pt idx="22">20</cx:pt>
          <cx:pt idx="23">10</cx:pt>
          <cx:pt idx="24">102</cx:pt>
          <cx:pt idx="25">30</cx:pt>
          <cx:pt idx="26">19</cx:pt>
          <cx:pt idx="27">64</cx:pt>
          <cx:pt idx="28">8</cx:pt>
          <cx:pt idx="29">42</cx:pt>
          <cx:pt idx="30">50</cx:pt>
          <cx:pt idx="31">14</cx:pt>
          <cx:pt idx="32">39</cx:pt>
          <cx:pt idx="33">43</cx:pt>
          <cx:pt idx="34">34</cx:pt>
          <cx:pt idx="35">10</cx:pt>
          <cx:pt idx="36">50</cx:pt>
          <cx:pt idx="37">21</cx:pt>
          <cx:pt idx="38">21</cx:pt>
          <cx:pt idx="39">26</cx:pt>
          <cx:pt idx="40">32</cx:pt>
          <cx:pt idx="41">21</cx:pt>
          <cx:pt idx="42">64</cx:pt>
          <cx:pt idx="43">13</cx:pt>
          <cx:pt idx="44">23</cx:pt>
          <cx:pt idx="45">67</cx:pt>
          <cx:pt idx="46">26</cx:pt>
          <cx:pt idx="47">30</cx:pt>
          <cx:pt idx="48">45</cx:pt>
        </cx:lvl>
      </cx:numDim>
    </cx:data>
  </cx:chartData>
  <cx:chart>
    <cx:title pos="t" align="ctr" overlay="0">
      <cx:tx>
        <cx:txData>
          <cx:v>Hospital stay</cx:v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>
              <a:solidFill>
                <a:schemeClr val="tx1"/>
              </a:solidFill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defRPr>
          </a:pPr>
          <a:r>
            <a:rPr lang="en-US" baseline="0" dirty="0">
              <a:solidFill>
                <a:schemeClr val="tx1"/>
              </a:solidFill>
              <a:latin typeface="Palatino Linotype" panose="02040502050505030304" pitchFamily="18" charset="0"/>
            </a:rPr>
            <a:t>Hospital stay</a:t>
          </a:r>
        </a:p>
      </cx:txPr>
    </cx:title>
    <cx:plotArea>
      <cx:plotAreaRegion>
        <cx:series layoutId="boxWhisker" uniqueId="{4182C088-BBF1-40C3-8A6B-46B290DE937D}">
          <cx:spPr>
            <a:solidFill>
              <a:schemeClr val="bg1"/>
            </a:solidFill>
            <a:ln w="6350">
              <a:solidFill>
                <a:schemeClr val="tx1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rgbClr val="595959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latin typeface="Palatino Linotype" panose="02040502050505030304" pitchFamily="18" charset="0"/>
            </a:endParaRPr>
          </a:p>
        </cx:txPr>
      </cx:axis>
      <cx:axis id="1">
        <cx:valScaling/>
        <cx:majorGridlines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defRPr>
            </a:pPr>
            <a:endParaRPr lang="ja-JP" altLang="en-US">
              <a:solidFill>
                <a:schemeClr val="tx1"/>
              </a:solidFill>
              <a:latin typeface="Palatino Linotype" panose="02040502050505030304" pitchFamily="18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6AEC88-1012-42FF-A42C-EBDBA159B6E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919577-66B0-4064-8BFA-389C96A31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17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. Comparison of abdominal and non-abdominal patients</a:t>
            </a:r>
          </a:p>
          <a:p>
            <a:pPr algn="just"/>
            <a:endParaRPr lang="en-US" altLang="ja-JP" sz="1200" kern="100" dirty="0">
              <a:effectLst/>
              <a:latin typeface="Palatino Linotype" panose="0204050205050503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tinuous variables were compared using Student’s t-test or the Mann–Whitney U test, as appropriate. </a:t>
            </a:r>
          </a:p>
          <a:p>
            <a:pPr algn="just"/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-square tests were performed for categorical variables .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e determined the significance level to be 5%.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breviations: </a:t>
            </a:r>
            <a:r>
              <a:rPr lang="en-US" altLang="ja-JP" sz="1200" i="1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SS</a:t>
            </a: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njury Severity Score; </a:t>
            </a:r>
            <a:r>
              <a:rPr lang="en-US" altLang="ja-JP" sz="1200" i="1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UT</a:t>
            </a: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Controlling Nutritional Status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endParaRPr lang="en-US" altLang="ja-JP" sz="1200" kern="100" dirty="0">
              <a:effectLst/>
              <a:latin typeface="Palatino Linotype" panose="0204050205050503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919577-66B0-4064-8BFA-389C96A3193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4542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ja-JP" sz="18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a. Receiver operating characteristic (ROC) curves for Injury Severity Score (ISS) on day 7 in non- surgical patients(n=20)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kumimoji="1" lang="en-US" altLang="ja-JP" dirty="0"/>
              <a:t>The area under the ROC </a:t>
            </a:r>
            <a:r>
              <a:rPr kumimoji="1" lang="ja-JP" altLang="en-US" dirty="0"/>
              <a:t>（</a:t>
            </a:r>
            <a:r>
              <a:rPr kumimoji="1" lang="en-US" altLang="ja-JP" dirty="0"/>
              <a:t>AUROC</a:t>
            </a:r>
            <a:r>
              <a:rPr kumimoji="1" lang="ja-JP" altLang="en-US" dirty="0"/>
              <a:t>）</a:t>
            </a:r>
            <a:r>
              <a:rPr kumimoji="1" lang="en-US" altLang="ja-JP" dirty="0"/>
              <a:t>value was</a:t>
            </a:r>
            <a:r>
              <a:rPr kumimoji="1" lang="ja-JP" altLang="en-US" dirty="0"/>
              <a:t>　</a:t>
            </a:r>
            <a:r>
              <a:rPr kumimoji="1" lang="en-US" altLang="ja-JP" dirty="0"/>
              <a:t>0.60, and the 95% confidence interval (CI) was 0.29-0.90. The ISS cutoff value was 27.5.</a:t>
            </a:r>
            <a:r>
              <a:rPr kumimoji="1" lang="ja-JP" altLang="en-US" dirty="0"/>
              <a:t>　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919577-66B0-4064-8BFA-389C96A3193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7829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ja-JP" sz="18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S2b. Receiver operating characteristic (ROC) curves for Injury Severity Score (ISS) on day 7 in surgical patients(n=29)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altLang="ja-JP" sz="1800" kern="100" dirty="0">
                <a:solidFill>
                  <a:srgbClr val="FF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The area under the ROC </a:t>
            </a:r>
            <a:r>
              <a:rPr lang="ja-JP" altLang="ja-JP" sz="1800" kern="100" dirty="0">
                <a:solidFill>
                  <a:srgbClr val="FF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（</a:t>
            </a:r>
            <a:r>
              <a:rPr lang="en-US" altLang="ja-JP" sz="1800" kern="100" dirty="0">
                <a:solidFill>
                  <a:srgbClr val="FF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AUROC</a:t>
            </a:r>
            <a:r>
              <a:rPr lang="ja-JP" altLang="ja-JP" sz="1800" kern="100" dirty="0">
                <a:solidFill>
                  <a:srgbClr val="FF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）</a:t>
            </a:r>
            <a:r>
              <a:rPr lang="en-US" altLang="ja-JP" sz="1800" kern="100" dirty="0">
                <a:solidFill>
                  <a:srgbClr val="FF0000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value was 0.71, and the 95% confidence interval (CI) was 0.51-0.90. The ISS cutoff value was 21.5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919577-66B0-4064-8BFA-389C96A3193D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2499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F739FE-C5B3-639F-49C4-05F47F88EE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59BBE1A-9A43-BC02-A343-F0F3BB2D46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149C4D-FA88-9C79-1D89-FBFCF5FBE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4E5D47-8627-FC1B-45F1-C7243AB86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4715FB-7007-6D56-3D89-F1B38FDA9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12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6E1B25-C18B-489D-32FC-25C3021A3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0598D7-0D65-215E-E525-A1DBFA4527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9397A3-9310-2C9B-E2A3-EDC17496B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AB9EAD-6590-BD3E-24B1-851CAAF9C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5F485A-F8AF-9038-53F5-280B2A138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806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F108D1F-487C-B6BC-F262-0F569DF09B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8B44C7-9D57-0CE7-CA32-52EF30E4F9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42F0C8-EB0F-20AD-76EC-6C5A44002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80D2B2-6203-505B-0B2B-B86C94964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E12772-9B6C-6465-8E02-50FD92B4A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6270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D9F969-AC8F-D3F5-F792-774E78931B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CD2768-0455-8EEC-FE9A-5D6438202B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59D7EF-E4B9-925E-FA30-F7EC4FEBF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860EA2-0211-00DF-6EA1-F17020AFC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D0518B0-171B-1CE9-2DDB-2034D7548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85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F5C30C-EED5-F8F6-47C7-EA7AD371C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EB22EB-3BD3-5BF0-6D78-B479943750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02BA39-6C71-B18C-9505-F87A6A145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0C09CA-5F36-2935-3A6A-8C43ADF39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893E27-1A16-2CEB-5616-8004323D3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47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CD7837-08B6-9386-B23B-104C1BD5BC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E40D40B-D339-BDA1-D149-A2648B965E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7BA3F8C-C2BE-B2DB-315B-CD03F00729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04B3E5F-4DD7-BE96-D6BC-2EF6DA928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603761-EC93-F745-28FB-A3AEAA8EA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38C83FF-86BD-CCED-94F2-93114BC44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63D4F8-6F8C-51E0-FCCC-8346707707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8196C0-931D-1536-F3D7-7643CC24C9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83253D-0E3C-C885-489E-B50E976751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D512D40-4A09-5643-3F06-AB7A0A44EB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875DA36-55C6-56D8-3213-46E8CA016C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80D6817-8BD4-DE34-9765-754AC4C14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268060B-A363-3B57-C8D7-0EBD840FC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A0879CC-366F-7F9D-0106-896E85919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114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8092EA-2A96-3499-A14E-904AA3272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DFFCAF7-9FFD-EE49-43B9-341C35E12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B94076E-D39C-D6FD-6D84-872224D2C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A45F6EF-8210-5B82-3869-6DE6E361D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979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7529705-EBC3-D67C-5C8E-456F8BD03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1FFBEA-7A25-7370-43BC-81B41C7ED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C3E53AA-E6D7-3142-D517-4CD136CA0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2775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2525F0-0680-FD34-BF70-6FA4B2F787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04670B1-A174-A856-BC23-A4A7FB222D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225EABE-B8FF-32F7-4575-DD1E47C175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D96EDD-039F-E548-EF6D-AC07F4396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81BD804-1069-EF16-7FFB-7CE68BA3D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694D75-CC1D-2EC0-F06C-D5CAE09C9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736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9506BE-3D35-2C22-40B9-49ED586B4C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6E6BE47-D2C3-235E-3C10-B8DC4863AB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B42B9B4-7FD4-CEF0-FF35-9C35A505B8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C21902-E1B9-006D-73A0-4A9EF46F9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A325C46-5F85-F94B-5FFD-8F958579C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B9D82EC-BF9F-282D-9BE0-3BE8F3917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065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21D9415-09F5-F84F-FEF4-8ECE73D9EC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9155A1B-AE2E-EF6E-2651-C3BCB22E6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05C91B-8069-CABE-190F-24E5C4ED8E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0FC09F-B846-4D81-888C-E24D369B3863}" type="datetimeFigureOut">
              <a:rPr kumimoji="1" lang="ja-JP" altLang="en-US" smtClean="0"/>
              <a:t>2024/6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B44DD3-8A7D-AE4A-37E5-98B22A9B6A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650690C-E2AF-EAE4-3E3F-984EC47D3C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9C10A4-54E9-4BE5-9E28-83D2F448DB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372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microsoft.com/office/2014/relationships/chartEx" Target="../charts/chartEx6.xml"/><Relationship Id="rId3" Type="http://schemas.microsoft.com/office/2014/relationships/chartEx" Target="../charts/chartEx1.xml"/><Relationship Id="rId7" Type="http://schemas.microsoft.com/office/2014/relationships/chartEx" Target="../charts/chartEx3.xml"/><Relationship Id="rId12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11" Type="http://schemas.microsoft.com/office/2014/relationships/chartEx" Target="../charts/chartEx5.xml"/><Relationship Id="rId5" Type="http://schemas.microsoft.com/office/2014/relationships/chartEx" Target="../charts/chartEx2.xml"/><Relationship Id="rId10" Type="http://schemas.openxmlformats.org/officeDocument/2006/relationships/image" Target="../media/image4.png"/><Relationship Id="rId4" Type="http://schemas.openxmlformats.org/officeDocument/2006/relationships/image" Target="../media/image1.png"/><Relationship Id="rId9" Type="http://schemas.microsoft.com/office/2014/relationships/chartEx" Target="../charts/chartEx4.xml"/><Relationship Id="rId14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7" name="Chart 7">
                <a:extLst>
                  <a:ext uri="{FF2B5EF4-FFF2-40B4-BE49-F238E27FC236}">
                    <a16:creationId xmlns:a16="http://schemas.microsoft.com/office/drawing/2014/main" id="{20BEF4AB-EBDA-7A08-9E21-6D1AD30F22EA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408305926"/>
                  </p:ext>
                </p:extLst>
              </p:nvPr>
            </p:nvGraphicFramePr>
            <p:xfrm>
              <a:off x="4071929" y="352213"/>
              <a:ext cx="4060241" cy="3150219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 xmlns="">
          <p:pic>
            <p:nvPicPr>
              <p:cNvPr id="17" name="Chart 7">
                <a:extLst>
                  <a:ext uri="{FF2B5EF4-FFF2-40B4-BE49-F238E27FC236}">
                    <a16:creationId xmlns:a16="http://schemas.microsoft.com/office/drawing/2014/main" id="{20BEF4AB-EBDA-7A08-9E21-6D1AD30F22EA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071929" y="352213"/>
                <a:ext cx="4060241" cy="3150219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5" name="グラフ 4">
                <a:extLst>
                  <a:ext uri="{FF2B5EF4-FFF2-40B4-BE49-F238E27FC236}">
                    <a16:creationId xmlns:a16="http://schemas.microsoft.com/office/drawing/2014/main" id="{3D3CA74C-FF90-58E3-5AAB-3835D01A178F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737852554"/>
                  </p:ext>
                </p:extLst>
              </p:nvPr>
            </p:nvGraphicFramePr>
            <p:xfrm>
              <a:off x="157844" y="352213"/>
              <a:ext cx="3973282" cy="315141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5"/>
              </a:graphicData>
            </a:graphic>
          </p:graphicFrame>
        </mc:Choice>
        <mc:Fallback xmlns="">
          <p:pic>
            <p:nvPicPr>
              <p:cNvPr id="5" name="グラフ 4">
                <a:extLst>
                  <a:ext uri="{FF2B5EF4-FFF2-40B4-BE49-F238E27FC236}">
                    <a16:creationId xmlns:a16="http://schemas.microsoft.com/office/drawing/2014/main" id="{3D3CA74C-FF90-58E3-5AAB-3835D01A178F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57844" y="352213"/>
                <a:ext cx="3973282" cy="315141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6" name="Chart 7">
                <a:extLst>
                  <a:ext uri="{FF2B5EF4-FFF2-40B4-BE49-F238E27FC236}">
                    <a16:creationId xmlns:a16="http://schemas.microsoft.com/office/drawing/2014/main" id="{CCA67E21-679C-CDD7-634A-A7C57607838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423125128"/>
                  </p:ext>
                </p:extLst>
              </p:nvPr>
            </p:nvGraphicFramePr>
            <p:xfrm>
              <a:off x="8134352" y="3615208"/>
              <a:ext cx="3973282" cy="315141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7"/>
              </a:graphicData>
            </a:graphic>
          </p:graphicFrame>
        </mc:Choice>
        <mc:Fallback xmlns="">
          <p:pic>
            <p:nvPicPr>
              <p:cNvPr id="6" name="Chart 7">
                <a:extLst>
                  <a:ext uri="{FF2B5EF4-FFF2-40B4-BE49-F238E27FC236}">
                    <a16:creationId xmlns:a16="http://schemas.microsoft.com/office/drawing/2014/main" id="{CCA67E21-679C-CDD7-634A-A7C57607838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34352" y="3615208"/>
                <a:ext cx="3973282" cy="315141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7" name="Chart 7">
                <a:extLst>
                  <a:ext uri="{FF2B5EF4-FFF2-40B4-BE49-F238E27FC236}">
                    <a16:creationId xmlns:a16="http://schemas.microsoft.com/office/drawing/2014/main" id="{1AB00137-A940-C7BB-4927-B6820D2865F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200660633"/>
                  </p:ext>
                </p:extLst>
              </p:nvPr>
            </p:nvGraphicFramePr>
            <p:xfrm>
              <a:off x="174174" y="3615208"/>
              <a:ext cx="3973282" cy="315141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9"/>
              </a:graphicData>
            </a:graphic>
          </p:graphicFrame>
        </mc:Choice>
        <mc:Fallback xmlns="">
          <p:pic>
            <p:nvPicPr>
              <p:cNvPr id="7" name="Chart 7">
                <a:extLst>
                  <a:ext uri="{FF2B5EF4-FFF2-40B4-BE49-F238E27FC236}">
                    <a16:creationId xmlns:a16="http://schemas.microsoft.com/office/drawing/2014/main" id="{1AB00137-A940-C7BB-4927-B6820D2865F5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74174" y="3615208"/>
                <a:ext cx="3973282" cy="315141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8" name="Chart 7">
                <a:extLst>
                  <a:ext uri="{FF2B5EF4-FFF2-40B4-BE49-F238E27FC236}">
                    <a16:creationId xmlns:a16="http://schemas.microsoft.com/office/drawing/2014/main" id="{BC471F31-4ED4-D751-6A92-2E67BE4C633F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623253753"/>
                  </p:ext>
                </p:extLst>
              </p:nvPr>
            </p:nvGraphicFramePr>
            <p:xfrm>
              <a:off x="4027711" y="3615208"/>
              <a:ext cx="4117521" cy="315141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1"/>
              </a:graphicData>
            </a:graphic>
          </p:graphicFrame>
        </mc:Choice>
        <mc:Fallback xmlns="">
          <p:pic>
            <p:nvPicPr>
              <p:cNvPr id="8" name="Chart 7">
                <a:extLst>
                  <a:ext uri="{FF2B5EF4-FFF2-40B4-BE49-F238E27FC236}">
                    <a16:creationId xmlns:a16="http://schemas.microsoft.com/office/drawing/2014/main" id="{BC471F31-4ED4-D751-6A92-2E67BE4C633F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027711" y="3615208"/>
                <a:ext cx="4117521" cy="315141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0" name="Chart 7">
                <a:extLst>
                  <a:ext uri="{FF2B5EF4-FFF2-40B4-BE49-F238E27FC236}">
                    <a16:creationId xmlns:a16="http://schemas.microsoft.com/office/drawing/2014/main" id="{4D805ECB-F5BA-6588-DD37-50F12FBF0E6E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777146923"/>
                  </p:ext>
                </p:extLst>
              </p:nvPr>
            </p:nvGraphicFramePr>
            <p:xfrm>
              <a:off x="8084123" y="311894"/>
              <a:ext cx="3973282" cy="3190538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3"/>
              </a:graphicData>
            </a:graphic>
          </p:graphicFrame>
        </mc:Choice>
        <mc:Fallback xmlns="">
          <p:pic>
            <p:nvPicPr>
              <p:cNvPr id="10" name="Chart 7">
                <a:extLst>
                  <a:ext uri="{FF2B5EF4-FFF2-40B4-BE49-F238E27FC236}">
                    <a16:creationId xmlns:a16="http://schemas.microsoft.com/office/drawing/2014/main" id="{4D805ECB-F5BA-6588-DD37-50F12FBF0E6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8084123" y="311894"/>
                <a:ext cx="3973282" cy="3190538"/>
              </a:xfrm>
              <a:prstGeom prst="rect">
                <a:avLst/>
              </a:prstGeom>
            </p:spPr>
          </p:pic>
        </mc:Fallback>
      </mc:AlternateContent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F42C239-960F-7491-614F-1C92D0FF782A}"/>
              </a:ext>
            </a:extLst>
          </p:cNvPr>
          <p:cNvSpPr txBox="1"/>
          <p:nvPr/>
        </p:nvSpPr>
        <p:spPr>
          <a:xfrm>
            <a:off x="4587100" y="3240822"/>
            <a:ext cx="331742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n-abdominal cases                   abdominal cases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DE2B27C-7327-0117-B376-FC5D9756390C}"/>
              </a:ext>
            </a:extLst>
          </p:cNvPr>
          <p:cNvSpPr txBox="1"/>
          <p:nvPr/>
        </p:nvSpPr>
        <p:spPr>
          <a:xfrm>
            <a:off x="1964871" y="1279870"/>
            <a:ext cx="8681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1100" dirty="0">
                <a:latin typeface="Palatino Linotype" panose="02040502050505030304" pitchFamily="18" charset="0"/>
              </a:rPr>
              <a:t>= 0.828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40180E5-B7A2-3B91-6CFC-E09FF77C17E9}"/>
              </a:ext>
            </a:extLst>
          </p:cNvPr>
          <p:cNvSpPr txBox="1"/>
          <p:nvPr/>
        </p:nvSpPr>
        <p:spPr>
          <a:xfrm>
            <a:off x="5759918" y="1183297"/>
            <a:ext cx="8681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1100" dirty="0">
                <a:latin typeface="Palatino Linotype" panose="02040502050505030304" pitchFamily="18" charset="0"/>
              </a:rPr>
              <a:t>= 0.005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C8D07B6-82F7-CA60-CF4A-34F04BE33880}"/>
              </a:ext>
            </a:extLst>
          </p:cNvPr>
          <p:cNvSpPr txBox="1"/>
          <p:nvPr/>
        </p:nvSpPr>
        <p:spPr>
          <a:xfrm>
            <a:off x="9686925" y="4545585"/>
            <a:ext cx="8681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1100" dirty="0">
                <a:latin typeface="Palatino Linotype" panose="02040502050505030304" pitchFamily="18" charset="0"/>
              </a:rPr>
              <a:t>= 0.146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51E33CA-B6DF-CAE1-9248-41C5D60A5A88}"/>
              </a:ext>
            </a:extLst>
          </p:cNvPr>
          <p:cNvSpPr txBox="1"/>
          <p:nvPr/>
        </p:nvSpPr>
        <p:spPr>
          <a:xfrm>
            <a:off x="1964870" y="4559192"/>
            <a:ext cx="8681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1100" dirty="0">
                <a:latin typeface="Palatino Linotype" panose="02040502050505030304" pitchFamily="18" charset="0"/>
              </a:rPr>
              <a:t>= 1.000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D019198-69A1-6590-4B8E-599E8260B98D}"/>
              </a:ext>
            </a:extLst>
          </p:cNvPr>
          <p:cNvSpPr txBox="1"/>
          <p:nvPr/>
        </p:nvSpPr>
        <p:spPr>
          <a:xfrm>
            <a:off x="5807529" y="4563097"/>
            <a:ext cx="8681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1100" dirty="0">
                <a:latin typeface="Palatino Linotype" panose="02040502050505030304" pitchFamily="18" charset="0"/>
              </a:rPr>
              <a:t>= 0.721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128C879-01D5-C1D2-D6B6-E4A071B028C8}"/>
              </a:ext>
            </a:extLst>
          </p:cNvPr>
          <p:cNvSpPr txBox="1"/>
          <p:nvPr/>
        </p:nvSpPr>
        <p:spPr>
          <a:xfrm>
            <a:off x="9733200" y="1255879"/>
            <a:ext cx="8681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Palatino Linotype" panose="02040502050505030304" pitchFamily="18" charset="0"/>
              </a:rPr>
              <a:t>p</a:t>
            </a:r>
            <a:r>
              <a:rPr lang="en-US" altLang="ja-JP" sz="1100" dirty="0">
                <a:latin typeface="Palatino Linotype" panose="02040502050505030304" pitchFamily="18" charset="0"/>
              </a:rPr>
              <a:t>= 0.596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2B51CF6-547B-E791-4133-FFDBC0E3158C}"/>
              </a:ext>
            </a:extLst>
          </p:cNvPr>
          <p:cNvSpPr txBox="1"/>
          <p:nvPr/>
        </p:nvSpPr>
        <p:spPr>
          <a:xfrm>
            <a:off x="740221" y="3208011"/>
            <a:ext cx="331742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n-abdominal cases               abdominal cases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4C90F7B-EA7D-6DC2-FD7F-348B6E4E4073}"/>
              </a:ext>
            </a:extLst>
          </p:cNvPr>
          <p:cNvSpPr txBox="1"/>
          <p:nvPr/>
        </p:nvSpPr>
        <p:spPr>
          <a:xfrm>
            <a:off x="73488" y="245097"/>
            <a:ext cx="57149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(kcal) 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7147F8B-1C72-DA8A-9534-BF8667DA62CE}"/>
              </a:ext>
            </a:extLst>
          </p:cNvPr>
          <p:cNvSpPr txBox="1"/>
          <p:nvPr/>
        </p:nvSpPr>
        <p:spPr>
          <a:xfrm>
            <a:off x="3859262" y="426185"/>
            <a:ext cx="57149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(days) 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47A46C2-EB6F-6DC1-BB8C-49A472A40266}"/>
              </a:ext>
            </a:extLst>
          </p:cNvPr>
          <p:cNvSpPr txBox="1"/>
          <p:nvPr/>
        </p:nvSpPr>
        <p:spPr>
          <a:xfrm>
            <a:off x="7903040" y="420761"/>
            <a:ext cx="57149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(days) 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98971A9-AEC2-DDDA-C056-67D27A4B9734}"/>
              </a:ext>
            </a:extLst>
          </p:cNvPr>
          <p:cNvSpPr txBox="1"/>
          <p:nvPr/>
        </p:nvSpPr>
        <p:spPr>
          <a:xfrm>
            <a:off x="4544791" y="6485626"/>
            <a:ext cx="331742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n-abdominal cases                   abdominal cases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26D182B-F06F-A7EF-982E-44229AC51225}"/>
              </a:ext>
            </a:extLst>
          </p:cNvPr>
          <p:cNvSpPr txBox="1"/>
          <p:nvPr/>
        </p:nvSpPr>
        <p:spPr>
          <a:xfrm>
            <a:off x="8599294" y="3449839"/>
            <a:ext cx="331742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n-abdominal cases                 abdominal cases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8A8591F-5796-AEF3-2AB3-5B4642DFDBD1}"/>
              </a:ext>
            </a:extLst>
          </p:cNvPr>
          <p:cNvSpPr txBox="1"/>
          <p:nvPr/>
        </p:nvSpPr>
        <p:spPr>
          <a:xfrm>
            <a:off x="8576047" y="6483699"/>
            <a:ext cx="331742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n-abdominal cases                  abdominal cases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7179AD3-E9C3-BD6F-E0B5-9EDE6AB4BB70}"/>
              </a:ext>
            </a:extLst>
          </p:cNvPr>
          <p:cNvSpPr txBox="1"/>
          <p:nvPr/>
        </p:nvSpPr>
        <p:spPr>
          <a:xfrm>
            <a:off x="644979" y="6485626"/>
            <a:ext cx="331742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n-abdominal cases                  abdominal cases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95D3267-0890-A922-BDDE-6641BA9537FB}"/>
              </a:ext>
            </a:extLst>
          </p:cNvPr>
          <p:cNvSpPr txBox="1"/>
          <p:nvPr/>
        </p:nvSpPr>
        <p:spPr>
          <a:xfrm>
            <a:off x="570420" y="2219725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Palatino Linotype" panose="02040502050505030304" pitchFamily="18" charset="0"/>
              </a:rPr>
              <a:t>6239.5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79C35B5-0C40-4F3E-8C77-91A7B5D3FF3A}"/>
              </a:ext>
            </a:extLst>
          </p:cNvPr>
          <p:cNvSpPr txBox="1"/>
          <p:nvPr/>
        </p:nvSpPr>
        <p:spPr>
          <a:xfrm>
            <a:off x="2302240" y="2226247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Palatino Linotype" panose="02040502050505030304" pitchFamily="18" charset="0"/>
              </a:rPr>
              <a:t>6234.0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EAE4787-B1B3-429C-ECEE-B2962A42F952}"/>
              </a:ext>
            </a:extLst>
          </p:cNvPr>
          <p:cNvSpPr txBox="1"/>
          <p:nvPr/>
        </p:nvSpPr>
        <p:spPr>
          <a:xfrm>
            <a:off x="4525220" y="2457079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9.0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98815E1-873E-D226-0ED1-49A4CCE0DEBD}"/>
              </a:ext>
            </a:extLst>
          </p:cNvPr>
          <p:cNvSpPr txBox="1"/>
          <p:nvPr/>
        </p:nvSpPr>
        <p:spPr>
          <a:xfrm>
            <a:off x="6313729" y="2026063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Palatino Linotype" panose="02040502050505030304" pitchFamily="18" charset="0"/>
              </a:rPr>
              <a:t>15.0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B378A0F-14B8-6530-51C5-AA0169F4BDDE}"/>
              </a:ext>
            </a:extLst>
          </p:cNvPr>
          <p:cNvSpPr txBox="1"/>
          <p:nvPr/>
        </p:nvSpPr>
        <p:spPr>
          <a:xfrm>
            <a:off x="10417761" y="4149277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Palatino Linotype" panose="02040502050505030304" pitchFamily="18" charset="0"/>
              </a:rPr>
              <a:t>36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3160804-91FA-9AD0-8C6D-F0AE51A43F43}"/>
              </a:ext>
            </a:extLst>
          </p:cNvPr>
          <p:cNvSpPr txBox="1"/>
          <p:nvPr/>
        </p:nvSpPr>
        <p:spPr>
          <a:xfrm>
            <a:off x="8591754" y="5320288"/>
            <a:ext cx="4027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17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5E3DE28-BF41-7BEB-1C95-65DCC8C2CDB5}"/>
              </a:ext>
            </a:extLst>
          </p:cNvPr>
          <p:cNvSpPr txBox="1"/>
          <p:nvPr/>
        </p:nvSpPr>
        <p:spPr>
          <a:xfrm>
            <a:off x="740221" y="5793689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1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8AA243A-8F79-148E-A3F2-DED4F75D4B41}"/>
              </a:ext>
            </a:extLst>
          </p:cNvPr>
          <p:cNvSpPr txBox="1"/>
          <p:nvPr/>
        </p:nvSpPr>
        <p:spPr>
          <a:xfrm>
            <a:off x="2528730" y="5250948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Palatino Linotype" panose="02040502050505030304" pitchFamily="18" charset="0"/>
              </a:rPr>
              <a:t>2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203C475-FDA4-75BA-4F19-5DAF30E5826B}"/>
              </a:ext>
            </a:extLst>
          </p:cNvPr>
          <p:cNvSpPr txBox="1"/>
          <p:nvPr/>
        </p:nvSpPr>
        <p:spPr>
          <a:xfrm>
            <a:off x="6444331" y="5323836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5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3164688-435C-3CDA-4899-843D4D36260E}"/>
              </a:ext>
            </a:extLst>
          </p:cNvPr>
          <p:cNvSpPr txBox="1"/>
          <p:nvPr/>
        </p:nvSpPr>
        <p:spPr>
          <a:xfrm>
            <a:off x="4544791" y="5529035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4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2CA1B89-B9A3-96BE-6808-5A76FF07BF72}"/>
              </a:ext>
            </a:extLst>
          </p:cNvPr>
          <p:cNvSpPr txBox="1"/>
          <p:nvPr/>
        </p:nvSpPr>
        <p:spPr>
          <a:xfrm>
            <a:off x="8599510" y="2387986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32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A4CEDF6-07B1-A578-580D-5E88EFF2F58C}"/>
              </a:ext>
            </a:extLst>
          </p:cNvPr>
          <p:cNvSpPr txBox="1"/>
          <p:nvPr/>
        </p:nvSpPr>
        <p:spPr>
          <a:xfrm>
            <a:off x="10354154" y="2427049"/>
            <a:ext cx="499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30</a:t>
            </a:r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4C325B3-CC4F-EA01-ECD3-5C92C515F965}"/>
              </a:ext>
            </a:extLst>
          </p:cNvPr>
          <p:cNvSpPr txBox="1"/>
          <p:nvPr/>
        </p:nvSpPr>
        <p:spPr>
          <a:xfrm>
            <a:off x="564423" y="123951"/>
            <a:ext cx="44165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. Comparison of abdominal and non-abdominal patients</a:t>
            </a:r>
          </a:p>
          <a:p>
            <a:endParaRPr kumimoji="1" lang="ja-JP" alt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2705261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241DA55-A994-2F06-9024-0276A5C7C3A6}"/>
              </a:ext>
            </a:extLst>
          </p:cNvPr>
          <p:cNvGrpSpPr/>
          <p:nvPr/>
        </p:nvGrpSpPr>
        <p:grpSpPr>
          <a:xfrm>
            <a:off x="3606647" y="1099552"/>
            <a:ext cx="4822215" cy="4672256"/>
            <a:chOff x="3606647" y="1099552"/>
            <a:chExt cx="4822215" cy="4672256"/>
          </a:xfrm>
        </p:grpSpPr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DBF58460-AE9C-C5AB-CDAF-5A6D2E91902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93165" y="1387473"/>
              <a:ext cx="4350539" cy="4119128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00C767A-341D-C39E-FECA-C3340F1628BC}"/>
                </a:ext>
              </a:extLst>
            </p:cNvPr>
            <p:cNvSpPr txBox="1"/>
            <p:nvPr/>
          </p:nvSpPr>
          <p:spPr>
            <a:xfrm>
              <a:off x="5586203" y="4201841"/>
              <a:ext cx="263886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AUROC=0.60; 95% CI 0.29–0.90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1158653-7D90-62F4-EB7E-D11D3BEA35B3}"/>
                </a:ext>
              </a:extLst>
            </p:cNvPr>
            <p:cNvSpPr txBox="1"/>
            <p:nvPr/>
          </p:nvSpPr>
          <p:spPr>
            <a:xfrm>
              <a:off x="7325675" y="5479420"/>
              <a:ext cx="1103187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-</a:t>
              </a:r>
              <a:r>
                <a:rPr kumimoji="1" lang="ja-JP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pecificity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3A1FC54-1843-1259-4077-63B272EA4C85}"/>
                </a:ext>
              </a:extLst>
            </p:cNvPr>
            <p:cNvSpPr txBox="1"/>
            <p:nvPr/>
          </p:nvSpPr>
          <p:spPr>
            <a:xfrm>
              <a:off x="4110035" y="3079877"/>
              <a:ext cx="82426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ISS 27.5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57FA6CFA-2E56-B814-64BA-9188608954E6}"/>
                </a:ext>
              </a:extLst>
            </p:cNvPr>
            <p:cNvSpPr txBox="1"/>
            <p:nvPr/>
          </p:nvSpPr>
          <p:spPr>
            <a:xfrm>
              <a:off x="3606647" y="1099552"/>
              <a:ext cx="907621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ensitivity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541EA630-AB1B-3DB2-6FB8-A45133266220}"/>
                </a:ext>
              </a:extLst>
            </p:cNvPr>
            <p:cNvSpPr/>
            <p:nvPr/>
          </p:nvSpPr>
          <p:spPr>
            <a:xfrm>
              <a:off x="5238750" y="1333500"/>
              <a:ext cx="965200" cy="10794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1D4BC24B-86FF-1641-E7A8-CD0C6DB85776}"/>
                </a:ext>
              </a:extLst>
            </p:cNvPr>
            <p:cNvSpPr/>
            <p:nvPr/>
          </p:nvSpPr>
          <p:spPr>
            <a:xfrm rot="10800000" flipV="1">
              <a:off x="4151819" y="5303083"/>
              <a:ext cx="3950781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C15CAC0D-1983-77F6-69DF-2A48336F0FEC}"/>
                </a:ext>
              </a:extLst>
            </p:cNvPr>
            <p:cNvCxnSpPr>
              <a:cxnSpLocks/>
            </p:cNvCxnSpPr>
            <p:nvPr/>
          </p:nvCxnSpPr>
          <p:spPr>
            <a:xfrm>
              <a:off x="4110035" y="5311045"/>
              <a:ext cx="38611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84E2038C-4DAD-816C-74BD-51EA6B2D7D8B}"/>
                </a:ext>
              </a:extLst>
            </p:cNvPr>
            <p:cNvCxnSpPr>
              <a:cxnSpLocks/>
            </p:cNvCxnSpPr>
            <p:nvPr/>
          </p:nvCxnSpPr>
          <p:spPr>
            <a:xfrm>
              <a:off x="4110035" y="1469036"/>
              <a:ext cx="0" cy="38420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35169C9-B96B-D86C-91FA-3DA1DA605D13}"/>
              </a:ext>
            </a:extLst>
          </p:cNvPr>
          <p:cNvSpPr txBox="1"/>
          <p:nvPr/>
        </p:nvSpPr>
        <p:spPr>
          <a:xfrm>
            <a:off x="1852044" y="247973"/>
            <a:ext cx="84609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a. Receiver operating characteristic (ROC) curves for Injury Severity Score (ISS) on day 7 in non- surgical patients(n=20)</a:t>
            </a:r>
            <a:endParaRPr kumimoji="1" lang="ja-JP" alt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2650453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EC7B08C6-980C-EE01-53A0-306C27DA41EF}"/>
              </a:ext>
            </a:extLst>
          </p:cNvPr>
          <p:cNvGrpSpPr/>
          <p:nvPr/>
        </p:nvGrpSpPr>
        <p:grpSpPr>
          <a:xfrm>
            <a:off x="3606647" y="1099552"/>
            <a:ext cx="4822215" cy="4672256"/>
            <a:chOff x="3606647" y="1099552"/>
            <a:chExt cx="4822215" cy="4672256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71F2264-529B-F775-10F7-3CB6CF4B0E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32403" y="1421010"/>
              <a:ext cx="4318827" cy="4091041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00C767A-341D-C39E-FECA-C3340F1628BC}"/>
                </a:ext>
              </a:extLst>
            </p:cNvPr>
            <p:cNvSpPr txBox="1"/>
            <p:nvPr/>
          </p:nvSpPr>
          <p:spPr>
            <a:xfrm>
              <a:off x="5586203" y="4201841"/>
              <a:ext cx="2731838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AUROC=0.</a:t>
              </a:r>
              <a:r>
                <a:rPr lang="en-US" altLang="ja-JP" sz="13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71</a:t>
              </a: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; 95% CI 0.</a:t>
              </a:r>
              <a:r>
                <a:rPr lang="en-US" altLang="ja-JP" sz="13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51</a:t>
              </a: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–0.90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1158653-7D90-62F4-EB7E-D11D3BEA35B3}"/>
                </a:ext>
              </a:extLst>
            </p:cNvPr>
            <p:cNvSpPr txBox="1"/>
            <p:nvPr/>
          </p:nvSpPr>
          <p:spPr>
            <a:xfrm>
              <a:off x="7325675" y="5479420"/>
              <a:ext cx="1103187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-</a:t>
              </a:r>
              <a:r>
                <a:rPr kumimoji="1" lang="ja-JP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pecificity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3A1FC54-1843-1259-4077-63B272EA4C85}"/>
                </a:ext>
              </a:extLst>
            </p:cNvPr>
            <p:cNvSpPr txBox="1"/>
            <p:nvPr/>
          </p:nvSpPr>
          <p:spPr>
            <a:xfrm>
              <a:off x="4514268" y="2492048"/>
              <a:ext cx="82426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ISS 2</a:t>
              </a:r>
              <a:r>
                <a:rPr lang="en-US" altLang="ja-JP" sz="13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</a:t>
              </a: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.5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57FA6CFA-2E56-B814-64BA-9188608954E6}"/>
                </a:ext>
              </a:extLst>
            </p:cNvPr>
            <p:cNvSpPr txBox="1"/>
            <p:nvPr/>
          </p:nvSpPr>
          <p:spPr>
            <a:xfrm>
              <a:off x="3606647" y="1099552"/>
              <a:ext cx="907621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ensitivity</a:t>
              </a:r>
              <a:endParaRPr kumimoji="1" lang="ja-JP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1D4BC24B-86FF-1641-E7A8-CD0C6DB85776}"/>
                </a:ext>
              </a:extLst>
            </p:cNvPr>
            <p:cNvSpPr/>
            <p:nvPr/>
          </p:nvSpPr>
          <p:spPr>
            <a:xfrm rot="10800000" flipV="1">
              <a:off x="4151819" y="5303083"/>
              <a:ext cx="3950781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C15CAC0D-1983-77F6-69DF-2A48336F0FEC}"/>
                </a:ext>
              </a:extLst>
            </p:cNvPr>
            <p:cNvCxnSpPr>
              <a:cxnSpLocks/>
            </p:cNvCxnSpPr>
            <p:nvPr/>
          </p:nvCxnSpPr>
          <p:spPr>
            <a:xfrm>
              <a:off x="4110035" y="5311045"/>
              <a:ext cx="38611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84E2038C-4DAD-816C-74BD-51EA6B2D7D8B}"/>
                </a:ext>
              </a:extLst>
            </p:cNvPr>
            <p:cNvCxnSpPr>
              <a:cxnSpLocks/>
            </p:cNvCxnSpPr>
            <p:nvPr/>
          </p:nvCxnSpPr>
          <p:spPr>
            <a:xfrm>
              <a:off x="4110035" y="1469036"/>
              <a:ext cx="0" cy="38420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9A57CF3-75DA-1FD8-4750-91BCF7D08B4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46763" y="1356414"/>
              <a:ext cx="233010" cy="225243"/>
            </a:xfrm>
            <a:prstGeom prst="rect">
              <a:avLst/>
            </a:prstGeom>
          </p:spPr>
        </p:pic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7EC4F27-A800-5DC5-5AF2-FBFEFADD2870}"/>
              </a:ext>
            </a:extLst>
          </p:cNvPr>
          <p:cNvSpPr txBox="1"/>
          <p:nvPr/>
        </p:nvSpPr>
        <p:spPr>
          <a:xfrm>
            <a:off x="2149017" y="340966"/>
            <a:ext cx="789671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S2b. Receiver operating characteristic (ROC) curves for Injury Severity Score (ISS) on day 7 in surgical patients(n=29)</a:t>
            </a:r>
            <a:endParaRPr lang="ja-JP" altLang="ja-JP" sz="1100" b="1" kern="100" dirty="0">
              <a:effectLst/>
              <a:latin typeface="Palatino Linotype" panose="0204050205050503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1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9916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359</Words>
  <Application>Microsoft Office PowerPoint</Application>
  <PresentationFormat>Widescreen</PresentationFormat>
  <Paragraphs>57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游明朝</vt:lpstr>
      <vt:lpstr>Arial</vt:lpstr>
      <vt:lpstr>Palatino Linotype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美紀 織田</dc:creator>
  <cp:lastModifiedBy>MDPI</cp:lastModifiedBy>
  <cp:revision>26</cp:revision>
  <dcterms:created xsi:type="dcterms:W3CDTF">2024-06-03T15:13:08Z</dcterms:created>
  <dcterms:modified xsi:type="dcterms:W3CDTF">2024-06-20T06:22:34Z</dcterms:modified>
</cp:coreProperties>
</file>